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4" r:id="rId2"/>
    <p:sldId id="271" r:id="rId3"/>
    <p:sldId id="273" r:id="rId4"/>
    <p:sldId id="270" r:id="rId5"/>
    <p:sldId id="275" r:id="rId6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364"/>
    <p:restoredTop sz="94662"/>
  </p:normalViewPr>
  <p:slideViewPr>
    <p:cSldViewPr snapToGrid="0">
      <p:cViewPr varScale="1">
        <p:scale>
          <a:sx n="88" d="100"/>
          <a:sy n="88" d="100"/>
        </p:scale>
        <p:origin x="176" y="5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4BBC8CD-E157-7F46-7570-1A736290A0E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A1CC903A-A783-04AC-48BC-232252EB49B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AD94DEE-C191-5937-A100-3426B6E9C8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B7FD3-DAF5-0E47-B982-507B024C6203}" type="datetimeFigureOut">
              <a:rPr lang="es-ES" smtClean="0"/>
              <a:t>24/7/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5DCB4ACE-88F5-A103-50F3-94F7B757E7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C8FDB220-4C1A-BC79-4E21-1C79F3D7A7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BDB1B5-C19E-2444-95D2-2215E14740A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80474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F4283D2-D097-BEFD-303E-9DCC75D3A3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7FE7A256-74FD-EB9C-EBAC-5B6DFBE2EC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722147B-8DD7-E4CA-E6F7-3EE8273BA4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B7FD3-DAF5-0E47-B982-507B024C6203}" type="datetimeFigureOut">
              <a:rPr lang="es-ES" smtClean="0"/>
              <a:t>24/7/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AFCEC45-5461-6992-B60A-D56C4D2C75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C81CF31D-6088-2411-93AB-E80FD5C3F7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BDB1B5-C19E-2444-95D2-2215E14740A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534631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9795DBD9-7C6B-0021-D22B-DD0C77D3C67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FB891FFB-1CE2-41B7-67C0-FFFFABB2757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1DF559A-F180-F215-EEC0-8B60F14417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B7FD3-DAF5-0E47-B982-507B024C6203}" type="datetimeFigureOut">
              <a:rPr lang="es-ES" smtClean="0"/>
              <a:t>24/7/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4172983-17A1-0E24-3503-214CC64FA9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4C560B3-B37D-C51F-621E-3CFD6FB89A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BDB1B5-C19E-2444-95D2-2215E14740A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163701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277C338-6CDE-5231-748A-00727B8458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20580CAE-C981-3425-DDC6-FDD81EFD0E7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3EB4544-4AEC-B6AE-AFFF-E19CF971EB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B7FD3-DAF5-0E47-B982-507B024C6203}" type="datetimeFigureOut">
              <a:rPr lang="es-ES" smtClean="0"/>
              <a:t>24/7/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8104EB2-86B5-C737-781E-95EAA4BC72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330DE45-0227-C636-750F-54B608EE42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BDB1B5-C19E-2444-95D2-2215E14740A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342431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363555F-9941-E4B4-B05E-C4D24E156D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6D6402AE-66D7-EFD2-A3A6-B02EBD1CAC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7F19D795-050B-0001-AC9E-A5B4840024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B7FD3-DAF5-0E47-B982-507B024C6203}" type="datetimeFigureOut">
              <a:rPr lang="es-ES" smtClean="0"/>
              <a:t>24/7/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D6E458A4-9836-55B3-788A-D4DF53AD25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8A7B475-A7DF-B615-B5B1-EFAAC4BDB3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BDB1B5-C19E-2444-95D2-2215E14740A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707992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07AB53A-BD53-096D-FD03-3B15E8EF5E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844A8ACF-B1D7-5A20-E9E7-78F2E542852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F2F047A6-FBD2-FFA0-1FA9-686EF1989A0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83B65E0D-E462-A0DB-015A-5299876D12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B7FD3-DAF5-0E47-B982-507B024C6203}" type="datetimeFigureOut">
              <a:rPr lang="es-ES" smtClean="0"/>
              <a:t>24/7/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B11294C7-F8F2-C3A0-511C-4AC83C209F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8FBD26FF-0E92-6673-F1F7-83F0911C4E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BDB1B5-C19E-2444-95D2-2215E14740A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56088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682FFE1-4E59-EBDC-DAFE-9A51CC658E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F55090C2-8E3A-0CA5-538A-1C85556D95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A2CD6961-C40F-F246-56FD-CDE951D0019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6C1C9C3F-EC4F-C666-504B-A33420AF343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47B2AF54-46BC-9AD7-39E8-AAFBA1B0C97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0730387D-7ADF-3DDC-F39B-5DB3695473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B7FD3-DAF5-0E47-B982-507B024C6203}" type="datetimeFigureOut">
              <a:rPr lang="es-ES" smtClean="0"/>
              <a:t>24/7/25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CC12FE9F-4F40-E6E4-8AD3-40ADF7D72D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8099DC76-D626-D51E-101C-9B97489DE3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BDB1B5-C19E-2444-95D2-2215E14740A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362738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F2758AE-3604-DC51-788C-FA6C11AB8F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3034003B-2BF8-9EDA-3E8C-B7875B2A0B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B7FD3-DAF5-0E47-B982-507B024C6203}" type="datetimeFigureOut">
              <a:rPr lang="es-ES" smtClean="0"/>
              <a:t>24/7/25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840066B9-5C94-32D1-1E2B-F67AC90707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54FC12CE-A193-EF4A-C606-7AC8370C4E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BDB1B5-C19E-2444-95D2-2215E14740A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173942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76A128F6-3666-184A-AA99-D4514E1285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B7FD3-DAF5-0E47-B982-507B024C6203}" type="datetimeFigureOut">
              <a:rPr lang="es-ES" smtClean="0"/>
              <a:t>24/7/25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68134C0F-E78C-7DF6-C48B-9F05E59AAB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B2366FAF-5778-AE03-73B1-B1B7CA84F7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BDB1B5-C19E-2444-95D2-2215E14740A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272652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33153D6-576B-30C7-C4C0-8D14BDB638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716A6EB3-490A-E0FF-8237-1A1109B3731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472DEEBA-D05E-30C7-6136-2C92C63488E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9C8CBBDD-38A6-C840-009E-409C965AD2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B7FD3-DAF5-0E47-B982-507B024C6203}" type="datetimeFigureOut">
              <a:rPr lang="es-ES" smtClean="0"/>
              <a:t>24/7/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5DFB9094-68BA-FE1B-552C-09DF5F95AA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6EF9AD84-B49D-E1B5-92F8-CF09B2E0CD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BDB1B5-C19E-2444-95D2-2215E14740A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284717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E123DBA-CE25-E69C-F264-EE1CDF7F09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65FC7570-2AA1-1ED4-B0F7-55BA472354F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E1E48FCB-C765-7938-7AA4-4085C887648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B2E38429-3EA3-559C-6F28-B58B2D69C1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CB7FD3-DAF5-0E47-B982-507B024C6203}" type="datetimeFigureOut">
              <a:rPr lang="es-ES" smtClean="0"/>
              <a:t>24/7/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79EA67A0-D931-E528-59FC-C06AD2EE61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A62E111B-E9D1-1B47-90B4-23FC3310DE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BDB1B5-C19E-2444-95D2-2215E14740A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172455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C410A509-D0A0-D5C4-E56C-F9F87A66B9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912BDC4D-D27A-DDD3-986B-64FE2730A9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CBCDCFC-8B13-9A41-9CEB-1C983515A83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1CB7FD3-DAF5-0E47-B982-507B024C6203}" type="datetimeFigureOut">
              <a:rPr lang="es-ES" smtClean="0"/>
              <a:t>24/7/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8AAE80E-7CD9-A5A7-562E-C36DC6E2516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94D1403-A6BB-5570-1778-56F37B34EEF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FBDB1B5-C19E-2444-95D2-2215E14740A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249649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hyperlink" Target="https://ftp.ncbi.nlm.nih.gov/genomes/all/GCA/001/430/935/GCA_001430935.1_ASM143093v1/GCA_001430935.1_ASM143093v1_fcs_report.txt" TargetMode="External"/><Relationship Id="rId2" Type="http://schemas.openxmlformats.org/officeDocument/2006/relationships/hyperlink" Target="https://ftp.ncbi.nlm.nih.gov/genomes/all/GCA/001/430/945/GCA_001430945.1_ASM143094v1/GCA_001430945.1_ASM143094v1_fcs_report.txt" TargetMode="External"/><Relationship Id="rId1" Type="http://schemas.openxmlformats.org/officeDocument/2006/relationships/slideLayout" Target="../slideLayouts/slideLayout2.xml"/><Relationship Id="rId5" Type="http://schemas.openxmlformats.org/officeDocument/2006/relationships/hyperlink" Target="https://ftp.ncbi.nlm.nih.gov/genomes/all/GCA/001/430/955/GCA_001430955.1_ASM143095v1/GCA_001430955.1_ASM143095v1_fcs_report.txt" TargetMode="External"/><Relationship Id="rId4" Type="http://schemas.openxmlformats.org/officeDocument/2006/relationships/hyperlink" Target="https://ftp.ncbi.nlm.nih.gov/genomes/all/GCA/001/430/925/GCA_001430925.1_ASM143092v1/GCA_001430925.1_ASM143092v1_fcs_report.txt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ángulo 3"/>
          <p:cNvSpPr/>
          <p:nvPr/>
        </p:nvSpPr>
        <p:spPr>
          <a:xfrm>
            <a:off x="2264612" y="1993509"/>
            <a:ext cx="7951729" cy="206310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2800" dirty="0" err="1">
                <a:solidFill>
                  <a:schemeClr val="tx1"/>
                </a:solidFill>
              </a:rPr>
              <a:t>Supplementary</a:t>
            </a:r>
            <a:r>
              <a:rPr lang="es-ES" sz="2800" dirty="0">
                <a:solidFill>
                  <a:schemeClr val="tx1"/>
                </a:solidFill>
              </a:rPr>
              <a:t> material </a:t>
            </a:r>
          </a:p>
        </p:txBody>
      </p:sp>
    </p:spTree>
    <p:extLst>
      <p:ext uri="{BB962C8B-B14F-4D97-AF65-F5344CB8AC3E}">
        <p14:creationId xmlns:p14="http://schemas.microsoft.com/office/powerpoint/2010/main" val="11738931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a 3"/>
          <p:cNvGraphicFramePr>
            <a:graphicFrameLocks noGrp="1"/>
          </p:cNvGraphicFramePr>
          <p:nvPr/>
        </p:nvGraphicFramePr>
        <p:xfrm>
          <a:off x="169805" y="714898"/>
          <a:ext cx="11767269" cy="569306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176425">
                  <a:extLst>
                    <a:ext uri="{9D8B030D-6E8A-4147-A177-3AD203B41FA5}">
                      <a16:colId xmlns:a16="http://schemas.microsoft.com/office/drawing/2014/main" val="3837635828"/>
                    </a:ext>
                  </a:extLst>
                </a:gridCol>
                <a:gridCol w="1390733">
                  <a:extLst>
                    <a:ext uri="{9D8B030D-6E8A-4147-A177-3AD203B41FA5}">
                      <a16:colId xmlns:a16="http://schemas.microsoft.com/office/drawing/2014/main" val="3226283133"/>
                    </a:ext>
                  </a:extLst>
                </a:gridCol>
                <a:gridCol w="962873">
                  <a:extLst>
                    <a:ext uri="{9D8B030D-6E8A-4147-A177-3AD203B41FA5}">
                      <a16:colId xmlns:a16="http://schemas.microsoft.com/office/drawing/2014/main" val="4281530005"/>
                    </a:ext>
                  </a:extLst>
                </a:gridCol>
                <a:gridCol w="1069271">
                  <a:extLst>
                    <a:ext uri="{9D8B030D-6E8A-4147-A177-3AD203B41FA5}">
                      <a16:colId xmlns:a16="http://schemas.microsoft.com/office/drawing/2014/main" val="518304969"/>
                    </a:ext>
                  </a:extLst>
                </a:gridCol>
                <a:gridCol w="534258">
                  <a:extLst>
                    <a:ext uri="{9D8B030D-6E8A-4147-A177-3AD203B41FA5}">
                      <a16:colId xmlns:a16="http://schemas.microsoft.com/office/drawing/2014/main" val="34070112"/>
                    </a:ext>
                  </a:extLst>
                </a:gridCol>
                <a:gridCol w="749320">
                  <a:extLst>
                    <a:ext uri="{9D8B030D-6E8A-4147-A177-3AD203B41FA5}">
                      <a16:colId xmlns:a16="http://schemas.microsoft.com/office/drawing/2014/main" val="569833247"/>
                    </a:ext>
                  </a:extLst>
                </a:gridCol>
                <a:gridCol w="641412">
                  <a:extLst>
                    <a:ext uri="{9D8B030D-6E8A-4147-A177-3AD203B41FA5}">
                      <a16:colId xmlns:a16="http://schemas.microsoft.com/office/drawing/2014/main" val="3050790340"/>
                    </a:ext>
                  </a:extLst>
                </a:gridCol>
                <a:gridCol w="642167">
                  <a:extLst>
                    <a:ext uri="{9D8B030D-6E8A-4147-A177-3AD203B41FA5}">
                      <a16:colId xmlns:a16="http://schemas.microsoft.com/office/drawing/2014/main" val="2964084522"/>
                    </a:ext>
                  </a:extLst>
                </a:gridCol>
                <a:gridCol w="748566">
                  <a:extLst>
                    <a:ext uri="{9D8B030D-6E8A-4147-A177-3AD203B41FA5}">
                      <a16:colId xmlns:a16="http://schemas.microsoft.com/office/drawing/2014/main" val="4104564899"/>
                    </a:ext>
                  </a:extLst>
                </a:gridCol>
                <a:gridCol w="641412">
                  <a:extLst>
                    <a:ext uri="{9D8B030D-6E8A-4147-A177-3AD203B41FA5}">
                      <a16:colId xmlns:a16="http://schemas.microsoft.com/office/drawing/2014/main" val="1171110693"/>
                    </a:ext>
                  </a:extLst>
                </a:gridCol>
                <a:gridCol w="962873">
                  <a:extLst>
                    <a:ext uri="{9D8B030D-6E8A-4147-A177-3AD203B41FA5}">
                      <a16:colId xmlns:a16="http://schemas.microsoft.com/office/drawing/2014/main" val="1074576076"/>
                    </a:ext>
                  </a:extLst>
                </a:gridCol>
                <a:gridCol w="1070025">
                  <a:extLst>
                    <a:ext uri="{9D8B030D-6E8A-4147-A177-3AD203B41FA5}">
                      <a16:colId xmlns:a16="http://schemas.microsoft.com/office/drawing/2014/main" val="786728933"/>
                    </a:ext>
                  </a:extLst>
                </a:gridCol>
                <a:gridCol w="641412">
                  <a:extLst>
                    <a:ext uri="{9D8B030D-6E8A-4147-A177-3AD203B41FA5}">
                      <a16:colId xmlns:a16="http://schemas.microsoft.com/office/drawing/2014/main" val="913171590"/>
                    </a:ext>
                  </a:extLst>
                </a:gridCol>
                <a:gridCol w="536522">
                  <a:extLst>
                    <a:ext uri="{9D8B030D-6E8A-4147-A177-3AD203B41FA5}">
                      <a16:colId xmlns:a16="http://schemas.microsoft.com/office/drawing/2014/main" val="4014360504"/>
                    </a:ext>
                  </a:extLst>
                </a:gridCol>
              </a:tblGrid>
              <a:tr h="223113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b="1" dirty="0" err="1">
                          <a:effectLst/>
                        </a:rPr>
                        <a:t>Family</a:t>
                      </a:r>
                      <a:endParaRPr lang="es-ES" sz="11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b="1">
                          <a:effectLst/>
                        </a:rPr>
                        <a:t>Strain</a:t>
                      </a:r>
                      <a:endParaRPr lang="es-ES" sz="1100" b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b="1" dirty="0" err="1">
                          <a:effectLst/>
                        </a:rPr>
                        <a:t>GenBank</a:t>
                      </a:r>
                      <a:r>
                        <a:rPr lang="es-ES" sz="700" b="1" dirty="0">
                          <a:effectLst/>
                        </a:rPr>
                        <a:t> </a:t>
                      </a:r>
                      <a:r>
                        <a:rPr lang="es-ES" sz="700" b="1" dirty="0" err="1">
                          <a:effectLst/>
                        </a:rPr>
                        <a:t>assambly</a:t>
                      </a:r>
                      <a:r>
                        <a:rPr lang="es-ES" sz="700" b="1" dirty="0">
                          <a:effectLst/>
                        </a:rPr>
                        <a:t> </a:t>
                      </a:r>
                      <a:r>
                        <a:rPr lang="es-ES" sz="700" b="1" dirty="0" err="1">
                          <a:effectLst/>
                        </a:rPr>
                        <a:t>accession</a:t>
                      </a:r>
                      <a:endParaRPr lang="es-ES" sz="11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b="1">
                          <a:effectLst/>
                        </a:rPr>
                        <a:t>Size (Mb)</a:t>
                      </a:r>
                      <a:endParaRPr lang="es-ES" sz="1100" b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b="1">
                          <a:effectLst/>
                        </a:rPr>
                        <a:t>GC (%)</a:t>
                      </a:r>
                      <a:endParaRPr lang="es-ES" sz="1100" b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b="1">
                          <a:effectLst/>
                        </a:rPr>
                        <a:t>Contigs</a:t>
                      </a:r>
                      <a:endParaRPr lang="es-ES" sz="1100" b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b="1" dirty="0">
                          <a:effectLst/>
                        </a:rPr>
                        <a:t>L50 </a:t>
                      </a:r>
                      <a:endParaRPr lang="es-ES" sz="11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b="1">
                          <a:effectLst/>
                        </a:rPr>
                        <a:t># N's per 100 kbp</a:t>
                      </a:r>
                      <a:endParaRPr lang="es-ES" sz="1100" b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b="1">
                          <a:effectLst/>
                        </a:rPr>
                        <a:t>Complete BUSCOs (%)</a:t>
                      </a:r>
                      <a:endParaRPr lang="es-ES" sz="1100" b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700" b="1">
                          <a:effectLst/>
                        </a:rPr>
                        <a:t>Complete and single-copy BUSCOs (S)</a:t>
                      </a:r>
                      <a:endParaRPr lang="es-ES" sz="1100" b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700" b="1">
                          <a:effectLst/>
                        </a:rPr>
                        <a:t>Complete and duplicated BUSCOs (D)</a:t>
                      </a:r>
                      <a:endParaRPr lang="es-ES" sz="1100" b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b="1">
                          <a:effectLst/>
                        </a:rPr>
                        <a:t>Fragmented BUSCOs (F)</a:t>
                      </a:r>
                      <a:endParaRPr lang="es-ES" sz="1100" b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b="1" dirty="0" err="1">
                          <a:effectLst/>
                        </a:rPr>
                        <a:t>Missing</a:t>
                      </a:r>
                      <a:r>
                        <a:rPr lang="es-ES" sz="700" b="1" dirty="0">
                          <a:effectLst/>
                        </a:rPr>
                        <a:t> </a:t>
                      </a:r>
                      <a:r>
                        <a:rPr lang="es-ES" sz="700" b="1" dirty="0" err="1">
                          <a:effectLst/>
                        </a:rPr>
                        <a:t>BUSCOs</a:t>
                      </a:r>
                      <a:endParaRPr lang="es-ES" sz="11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3385937826"/>
                  </a:ext>
                </a:extLst>
              </a:tr>
              <a:tr h="1115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 dirty="0">
                          <a:effectLst/>
                        </a:rPr>
                        <a:t>Onygenaceae</a:t>
                      </a:r>
                      <a:endParaRPr lang="es-ES" sz="11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 dirty="0">
                          <a:effectLst/>
                        </a:rPr>
                        <a:t>Amauroascus </a:t>
                      </a:r>
                      <a:r>
                        <a:rPr lang="es-ES" sz="700" i="1" dirty="0" err="1">
                          <a:effectLst/>
                        </a:rPr>
                        <a:t>niger</a:t>
                      </a:r>
                      <a:endParaRPr lang="es-ES" sz="11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UAMH 354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GCA_001430945.1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36,71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50.09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3,48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8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5,647.8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96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5.7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8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3.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187627578"/>
                  </a:ext>
                </a:extLst>
              </a:tr>
              <a:tr h="1115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Onygenaceae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 dirty="0">
                          <a:effectLst/>
                        </a:rPr>
                        <a:t>Amauroascus </a:t>
                      </a:r>
                      <a:r>
                        <a:rPr lang="es-ES" sz="700" i="1" dirty="0" err="1">
                          <a:effectLst/>
                        </a:rPr>
                        <a:t>verrucosus</a:t>
                      </a:r>
                      <a:endParaRPr lang="es-ES" sz="11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UAMH 3576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GCA_001430935.1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30,37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9.2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3,07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40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8,888.5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96.7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6.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7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.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2928293900"/>
                  </a:ext>
                </a:extLst>
              </a:tr>
              <a:tr h="1115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Onygenaceae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 dirty="0">
                          <a:effectLst/>
                        </a:rPr>
                        <a:t>Aphanoascus </a:t>
                      </a:r>
                      <a:r>
                        <a:rPr lang="es-ES" sz="700" i="1" dirty="0" err="1">
                          <a:effectLst/>
                        </a:rPr>
                        <a:t>verrucosus</a:t>
                      </a:r>
                      <a:endParaRPr lang="es-ES" sz="11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IHEM 4434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GCA_014839905.1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3,0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9.59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1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17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10.51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6.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95.3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1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7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7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3846127411"/>
                  </a:ext>
                </a:extLst>
              </a:tr>
              <a:tr h="1115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Onygenaceae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Brunneospora queenslandica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CBS 280.77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GCA_001430955.1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32,33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53.15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,72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7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6,001.89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6.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9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.8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2550516076"/>
                  </a:ext>
                </a:extLst>
              </a:tr>
              <a:tr h="1115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Onygenaceae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 dirty="0">
                          <a:effectLst/>
                        </a:rPr>
                        <a:t>Byssoonygena </a:t>
                      </a:r>
                      <a:r>
                        <a:rPr lang="es-ES" sz="700" i="1" dirty="0" err="1">
                          <a:effectLst/>
                        </a:rPr>
                        <a:t>ceratinophila</a:t>
                      </a:r>
                      <a:endParaRPr lang="es-ES" sz="11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UAMH 5669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GCA_001430925.1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27,45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48.44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,85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67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6,870.5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4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3.9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.9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2738616804"/>
                  </a:ext>
                </a:extLst>
              </a:tr>
              <a:tr h="1115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Onygenaceae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 dirty="0" err="1">
                          <a:effectLst/>
                        </a:rPr>
                        <a:t>Chrysosoporium</a:t>
                      </a:r>
                      <a:r>
                        <a:rPr lang="es-ES" sz="700" i="1" dirty="0">
                          <a:effectLst/>
                        </a:rPr>
                        <a:t> </a:t>
                      </a:r>
                      <a:r>
                        <a:rPr lang="es-ES" sz="700" i="1" dirty="0" err="1">
                          <a:effectLst/>
                        </a:rPr>
                        <a:t>keratinophilum</a:t>
                      </a:r>
                      <a:endParaRPr lang="es-ES" sz="11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CBS 104.62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GCA_029850275.1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25,43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9.09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4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10.06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96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4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.9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3.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1873289724"/>
                  </a:ext>
                </a:extLst>
              </a:tr>
              <a:tr h="1115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Onygenaceae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 dirty="0">
                          <a:effectLst/>
                        </a:rPr>
                        <a:t>Coccidioides </a:t>
                      </a:r>
                      <a:r>
                        <a:rPr lang="es-ES" sz="700" i="1" dirty="0" err="1">
                          <a:effectLst/>
                        </a:rPr>
                        <a:t>immitis</a:t>
                      </a:r>
                      <a:endParaRPr lang="es-ES" sz="11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RS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GCA_000149335.2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29,01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45.96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7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3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.38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96.8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6.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.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2784637747"/>
                  </a:ext>
                </a:extLst>
              </a:tr>
              <a:tr h="1115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 dirty="0">
                          <a:effectLst/>
                        </a:rPr>
                        <a:t>Onygenaceae</a:t>
                      </a:r>
                      <a:endParaRPr lang="es-ES" sz="11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 dirty="0">
                          <a:effectLst/>
                        </a:rPr>
                        <a:t>Coccidioides </a:t>
                      </a:r>
                      <a:r>
                        <a:rPr lang="es-ES" sz="700" i="1" dirty="0" err="1">
                          <a:effectLst/>
                        </a:rPr>
                        <a:t>posadasii</a:t>
                      </a:r>
                      <a:endParaRPr lang="es-ES" sz="11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C735 delta </a:t>
                      </a:r>
                      <a:r>
                        <a:rPr lang="es-ES" sz="700" dirty="0" err="1">
                          <a:effectLst/>
                        </a:rPr>
                        <a:t>SOWgp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GCA_000151335.1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27,01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6.59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5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1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96.8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6.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.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2170188443"/>
                  </a:ext>
                </a:extLst>
              </a:tr>
              <a:tr h="1115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 dirty="0">
                          <a:effectLst/>
                        </a:rPr>
                        <a:t>Onygenaceae</a:t>
                      </a:r>
                      <a:endParaRPr lang="es-ES" sz="11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 dirty="0" err="1">
                          <a:effectLst/>
                        </a:rPr>
                        <a:t>Nannizziopsis</a:t>
                      </a:r>
                      <a:r>
                        <a:rPr lang="es-ES" sz="700" i="1" dirty="0">
                          <a:effectLst/>
                        </a:rPr>
                        <a:t> </a:t>
                      </a:r>
                      <a:r>
                        <a:rPr lang="es-ES" sz="700" i="1" dirty="0" err="1">
                          <a:effectLst/>
                        </a:rPr>
                        <a:t>barbatae</a:t>
                      </a:r>
                      <a:endParaRPr lang="es-ES" sz="11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USC00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GCA_014964245.1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31,54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40.36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0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94.5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4.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.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790096447"/>
                  </a:ext>
                </a:extLst>
              </a:tr>
              <a:tr h="1115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Onygenaceae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 dirty="0">
                          <a:effectLst/>
                        </a:rPr>
                        <a:t>Ophidiomyces ophidiicola</a:t>
                      </a:r>
                      <a:endParaRPr lang="es-ES" sz="11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MYCO-ARIZ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GCA_002167195.1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21,97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7.6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1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.8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94.8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4.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.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108735912"/>
                  </a:ext>
                </a:extLst>
              </a:tr>
              <a:tr h="1115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Onygenaceae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 dirty="0">
                          <a:effectLst/>
                        </a:rPr>
                        <a:t>Uncinocarpus </a:t>
                      </a:r>
                      <a:r>
                        <a:rPr lang="es-ES" sz="700" i="1" dirty="0" err="1">
                          <a:effectLst/>
                        </a:rPr>
                        <a:t>reesii</a:t>
                      </a:r>
                      <a:endParaRPr lang="es-ES" sz="11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UAMH 170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GCA_000003515.2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22,34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48.66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812.87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93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2.8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3.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3.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1933283882"/>
                  </a:ext>
                </a:extLst>
              </a:tr>
              <a:tr h="1115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Ajellomycetaceae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Blastomyces dermatitidis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ER-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GCA_000003525.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66,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37.07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7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507.4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7.7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7.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.7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436005078"/>
                  </a:ext>
                </a:extLst>
              </a:tr>
              <a:tr h="1115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 dirty="0">
                          <a:effectLst/>
                        </a:rPr>
                        <a:t>Ajellomycetaceae</a:t>
                      </a:r>
                      <a:endParaRPr lang="es-ES" sz="11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 dirty="0" err="1">
                          <a:effectLst/>
                        </a:rPr>
                        <a:t>Blastomyces</a:t>
                      </a:r>
                      <a:r>
                        <a:rPr lang="es-ES" sz="700" i="1" dirty="0">
                          <a:effectLst/>
                        </a:rPr>
                        <a:t> </a:t>
                      </a:r>
                      <a:r>
                        <a:rPr lang="es-ES" sz="700" i="1" dirty="0" err="1">
                          <a:effectLst/>
                        </a:rPr>
                        <a:t>emzantsi</a:t>
                      </a:r>
                      <a:endParaRPr lang="es-ES" sz="11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MRL_BACNE1992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GCA_003206725.1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34,0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51.4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3,36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349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71.6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5.8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5.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2768610566"/>
                  </a:ext>
                </a:extLst>
              </a:tr>
              <a:tr h="1115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Ajellomycetaceae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 dirty="0" err="1">
                          <a:effectLst/>
                        </a:rPr>
                        <a:t>Blastomyces</a:t>
                      </a:r>
                      <a:r>
                        <a:rPr lang="es-ES" sz="700" i="1" dirty="0">
                          <a:effectLst/>
                        </a:rPr>
                        <a:t> </a:t>
                      </a:r>
                      <a:r>
                        <a:rPr lang="es-ES" sz="700" i="1" dirty="0" err="1">
                          <a:effectLst/>
                        </a:rPr>
                        <a:t>gilchristii</a:t>
                      </a:r>
                      <a:endParaRPr lang="es-ES" sz="11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SLH1408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GCA_000003855.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75,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35.7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0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8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,340.7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97.6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7.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0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7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.7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4049340928"/>
                  </a:ext>
                </a:extLst>
              </a:tr>
              <a:tr h="1115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Ajellomycetaceae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 dirty="0" err="1">
                          <a:effectLst/>
                        </a:rPr>
                        <a:t>Blastomyces</a:t>
                      </a:r>
                      <a:r>
                        <a:rPr lang="es-ES" sz="700" i="1" dirty="0">
                          <a:effectLst/>
                        </a:rPr>
                        <a:t> </a:t>
                      </a:r>
                      <a:r>
                        <a:rPr lang="es-ES" sz="700" i="1" dirty="0" err="1">
                          <a:effectLst/>
                        </a:rPr>
                        <a:t>percursus</a:t>
                      </a:r>
                      <a:endParaRPr lang="es-ES" sz="11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IHEM 26956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GCA_018296065.1 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32,69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7.39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,78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74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87.6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6.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6.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.8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.8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98407820"/>
                  </a:ext>
                </a:extLst>
              </a:tr>
              <a:tr h="1115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Ajellomycetaceae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 dirty="0" err="1">
                          <a:effectLst/>
                        </a:rPr>
                        <a:t>Blastomyces</a:t>
                      </a:r>
                      <a:r>
                        <a:rPr lang="es-ES" sz="700" i="1" dirty="0">
                          <a:effectLst/>
                        </a:rPr>
                        <a:t> </a:t>
                      </a:r>
                      <a:r>
                        <a:rPr lang="es-ES" sz="700" i="1" dirty="0" err="1">
                          <a:effectLst/>
                        </a:rPr>
                        <a:t>silverae</a:t>
                      </a:r>
                      <a:endParaRPr lang="es-ES" sz="11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UAMH 139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GCA_001014755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30,9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4.4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3,70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8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741.0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88.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88.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5.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6.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1206733440"/>
                  </a:ext>
                </a:extLst>
              </a:tr>
              <a:tr h="1115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Ajellomycetaceae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Emergomyces africanus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CBS 13626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GCA_001660665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9,7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3.4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,44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59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.7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89.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88.8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6.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757769675"/>
                  </a:ext>
                </a:extLst>
              </a:tr>
              <a:tr h="1115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Ajellomycetaceae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Emergomyces orientalis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5z489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GCA_002110485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35,49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5.6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08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0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8.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8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.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1423895981"/>
                  </a:ext>
                </a:extLst>
              </a:tr>
              <a:tr h="1115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Ajellomycetaceae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Emergomyces pasteurensis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UAMH 951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GCA_001883825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32,4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4.48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,64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0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89.88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7.8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7.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7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.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4096618416"/>
                  </a:ext>
                </a:extLst>
              </a:tr>
              <a:tr h="1115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Ajellomycetaceae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Emmonsia crescens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UAMH 407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GCA_002572855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33,7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2.9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,288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0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4.17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8.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8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.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424879018"/>
                  </a:ext>
                </a:extLst>
              </a:tr>
              <a:tr h="1115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Ajellomycetaceae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 dirty="0" err="1">
                          <a:effectLst/>
                        </a:rPr>
                        <a:t>Emmonsia</a:t>
                      </a:r>
                      <a:r>
                        <a:rPr lang="es-ES" sz="700" i="1" dirty="0">
                          <a:effectLst/>
                        </a:rPr>
                        <a:t> parva</a:t>
                      </a:r>
                      <a:endParaRPr lang="es-ES" sz="11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UAMH 13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GCA_002572885.1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27,83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7.48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38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5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5.3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8.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8.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.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984850437"/>
                  </a:ext>
                </a:extLst>
              </a:tr>
              <a:tr h="1115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Ajellomycetaceae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Helicocarpus griseus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UAMH 5409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GCA_002573585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32,0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7.97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54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78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4.8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8.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8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408929108"/>
                  </a:ext>
                </a:extLst>
              </a:tr>
              <a:tr h="1115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Ajellomycetaceae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Histoplasma capsulatum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G186AR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GCA_000150115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30,48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4.5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88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660.58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6.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6.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.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2237651990"/>
                  </a:ext>
                </a:extLst>
              </a:tr>
              <a:tr h="1115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Ajellomycetaceae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 dirty="0">
                          <a:effectLst/>
                        </a:rPr>
                        <a:t>Histoplasma </a:t>
                      </a:r>
                      <a:r>
                        <a:rPr lang="es-ES" sz="700" i="1" dirty="0" err="1">
                          <a:effectLst/>
                        </a:rPr>
                        <a:t>mississippiense</a:t>
                      </a:r>
                      <a:endParaRPr lang="es-ES" sz="11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NAm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GCA_000149585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33,0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6.1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8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7,208.57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88.9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88.9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5.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5.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3036089890"/>
                  </a:ext>
                </a:extLst>
              </a:tr>
              <a:tr h="1115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Ajellomycetaceae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 dirty="0">
                          <a:effectLst/>
                        </a:rPr>
                        <a:t>Histoplasma </a:t>
                      </a:r>
                      <a:r>
                        <a:rPr lang="es-ES" sz="700" i="1" dirty="0" err="1">
                          <a:effectLst/>
                        </a:rPr>
                        <a:t>ohiense</a:t>
                      </a:r>
                      <a:endParaRPr lang="es-ES" sz="11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G217B 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GCA_017607445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39,4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2.6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0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7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6.8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8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.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2595501881"/>
                  </a:ext>
                </a:extLst>
              </a:tr>
              <a:tr h="1115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Ajellomycetaceae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Paracoccidioides brasiliensis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Pb18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GCA_000150735.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9,9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4.3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57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,615.27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6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.9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191649373"/>
                  </a:ext>
                </a:extLst>
              </a:tr>
              <a:tr h="1115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Ajellomycetaceae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Paracoccidioides lutzii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Pb0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GCA_000150705.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32,9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2.8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1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11.2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6.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6.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.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.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887742685"/>
                  </a:ext>
                </a:extLst>
              </a:tr>
              <a:tr h="1115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Arthrodermataceae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 dirty="0">
                          <a:effectLst/>
                        </a:rPr>
                        <a:t>Arthroderma </a:t>
                      </a:r>
                      <a:r>
                        <a:rPr lang="es-ES" sz="700" i="1" dirty="0" err="1">
                          <a:effectLst/>
                        </a:rPr>
                        <a:t>crocatum</a:t>
                      </a:r>
                      <a:endParaRPr lang="es-ES" sz="11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CBS 281.48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GCA_000812245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1,7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8.1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52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3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0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6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6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.9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2036250070"/>
                  </a:ext>
                </a:extLst>
              </a:tr>
              <a:tr h="1115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Arthrodermataceae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 dirty="0" err="1">
                          <a:effectLst/>
                        </a:rPr>
                        <a:t>Arthroderma</a:t>
                      </a:r>
                      <a:r>
                        <a:rPr lang="es-ES" sz="700" i="1" dirty="0">
                          <a:effectLst/>
                        </a:rPr>
                        <a:t> </a:t>
                      </a:r>
                      <a:r>
                        <a:rPr lang="es-ES" sz="700" i="1" dirty="0" err="1">
                          <a:effectLst/>
                        </a:rPr>
                        <a:t>uncinatum</a:t>
                      </a:r>
                      <a:endParaRPr lang="es-ES" sz="11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CBS 119779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GCA_011692745.1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3,5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8.6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0.00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97.6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97.5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.9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3628237181"/>
                  </a:ext>
                </a:extLst>
              </a:tr>
              <a:tr h="1115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 dirty="0">
                          <a:effectLst/>
                        </a:rPr>
                        <a:t>Arthrodermataceae</a:t>
                      </a:r>
                      <a:endParaRPr lang="es-ES" sz="11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Microsporum audouinii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IHEM 2214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GCA_022344085.1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3,4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47.35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7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14.2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7.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97.5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0.1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0.9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.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1461949636"/>
                  </a:ext>
                </a:extLst>
              </a:tr>
              <a:tr h="1115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 dirty="0">
                          <a:effectLst/>
                        </a:rPr>
                        <a:t>Arthrodermataceae</a:t>
                      </a:r>
                      <a:endParaRPr lang="es-ES" sz="11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 dirty="0">
                          <a:effectLst/>
                        </a:rPr>
                        <a:t>Microsporum </a:t>
                      </a:r>
                      <a:r>
                        <a:rPr lang="es-ES" sz="700" i="1" dirty="0" err="1">
                          <a:effectLst/>
                        </a:rPr>
                        <a:t>canis</a:t>
                      </a:r>
                      <a:endParaRPr lang="es-ES" sz="11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CBS 11348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GCA_000151145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3,2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7.5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7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539.9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7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6.9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.9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2132535693"/>
                  </a:ext>
                </a:extLst>
              </a:tr>
              <a:tr h="1115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 dirty="0">
                          <a:effectLst/>
                        </a:rPr>
                        <a:t>Arthrodermataceae</a:t>
                      </a:r>
                      <a:endParaRPr lang="es-ES" sz="11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 dirty="0">
                          <a:effectLst/>
                        </a:rPr>
                        <a:t>Nannizzia </a:t>
                      </a:r>
                      <a:r>
                        <a:rPr lang="es-ES" sz="700" i="1" dirty="0" err="1">
                          <a:effectLst/>
                        </a:rPr>
                        <a:t>gypsea</a:t>
                      </a:r>
                      <a:endParaRPr lang="es-ES" sz="11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CBS 118893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GCA_000150975.2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3,27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8.4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9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676.42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7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97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.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.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1773946763"/>
                  </a:ext>
                </a:extLst>
              </a:tr>
              <a:tr h="1115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 dirty="0">
                          <a:effectLst/>
                        </a:rPr>
                        <a:t>Arthrodermataceae</a:t>
                      </a:r>
                      <a:endParaRPr lang="es-ES" sz="11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 dirty="0">
                          <a:effectLst/>
                        </a:rPr>
                        <a:t>Trichophyton </a:t>
                      </a:r>
                      <a:r>
                        <a:rPr lang="es-ES" sz="700" i="1" dirty="0" err="1">
                          <a:effectLst/>
                        </a:rPr>
                        <a:t>benhamiae</a:t>
                      </a:r>
                      <a:endParaRPr lang="es-ES" sz="11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CBS 112371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GCA_000151125.2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2,2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8.7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68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10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0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7.7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7.7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9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.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789881249"/>
                  </a:ext>
                </a:extLst>
              </a:tr>
              <a:tr h="1115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Arthrodermataceae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Trichophyton equinum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CBS 127.97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GCA_000151175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4,1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7.37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2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,820.1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2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.9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1419806059"/>
                  </a:ext>
                </a:extLst>
              </a:tr>
              <a:tr h="1115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Arthrodermataceae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Trichophyton interdigitale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UCMS-IGIB-CI1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GCA_019359935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2,0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8.7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81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0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9.6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7.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7.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.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350759622"/>
                  </a:ext>
                </a:extLst>
              </a:tr>
              <a:tr h="1115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Arthrodermataceae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Trichophyton kuryangei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IHEM 471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GCA_910591595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2,2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8.2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8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55.7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7.8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7.8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.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3302086988"/>
                  </a:ext>
                </a:extLst>
              </a:tr>
              <a:tr h="1115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Arthrodermataceae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Trichophyton mentagrophytes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D15P127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GCA_003664465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3,7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7.88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,84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8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.49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7.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7.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.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488953771"/>
                  </a:ext>
                </a:extLst>
              </a:tr>
              <a:tr h="1115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Arthrodermataceae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Trichophyton rubrum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CBS 11889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GCA_000151425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2,5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8.28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3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,784.5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6.9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6.9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.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.9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3450318043"/>
                  </a:ext>
                </a:extLst>
              </a:tr>
              <a:tr h="1115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Arthrodermataceae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Trichophyton schoenleinii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CMCC(F)T2s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GCA_018357685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3,77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7.2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0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7.9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7.9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7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.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1982744347"/>
                  </a:ext>
                </a:extLst>
              </a:tr>
              <a:tr h="1115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Arthrodermataceae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Trichophyton simii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IHEM 442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GCA_014839955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3,4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7.58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9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.4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8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8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8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.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476086697"/>
                  </a:ext>
                </a:extLst>
              </a:tr>
              <a:tr h="1115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Arthrodermataceae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Trichophyton soudanense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IHEM 1974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GCA_910592025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2,3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8.1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9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38.9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8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8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7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.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1720595029"/>
                  </a:ext>
                </a:extLst>
              </a:tr>
              <a:tr h="1115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Arthrodermataceae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 dirty="0">
                          <a:effectLst/>
                        </a:rPr>
                        <a:t>Trichophyton </a:t>
                      </a:r>
                      <a:r>
                        <a:rPr lang="es-ES" sz="700" i="1" dirty="0" err="1">
                          <a:effectLst/>
                        </a:rPr>
                        <a:t>tonsurans</a:t>
                      </a:r>
                      <a:endParaRPr lang="es-ES" sz="11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CBS 112818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GCA_000151455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2,98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8.1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1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,101.9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4.9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4.9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.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.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1691100353"/>
                  </a:ext>
                </a:extLst>
              </a:tr>
              <a:tr h="1115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Arthrodermataceae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 dirty="0">
                          <a:effectLst/>
                        </a:rPr>
                        <a:t>Trichophyton </a:t>
                      </a:r>
                      <a:r>
                        <a:rPr lang="es-ES" sz="700" i="1" dirty="0" err="1">
                          <a:effectLst/>
                        </a:rPr>
                        <a:t>verrucosum</a:t>
                      </a:r>
                      <a:endParaRPr lang="es-ES" sz="11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HKI 0517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GCA_000151505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2,5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8.2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52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7.9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7.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7.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.7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715455720"/>
                  </a:ext>
                </a:extLst>
              </a:tr>
              <a:tr h="1115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Arthrodermataceae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Trichophyton violaceum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IHEM 1377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GCA_910591785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2,19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8.3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9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55.2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7.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7.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9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.8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1092268036"/>
                  </a:ext>
                </a:extLst>
              </a:tr>
              <a:tr h="1115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Arthrodermataceae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>
                          <a:effectLst/>
                        </a:rPr>
                        <a:t>Trichophyton yaoundei</a:t>
                      </a:r>
                      <a:endParaRPr lang="es-ES" sz="1100" i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IHEM 1337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GCA_910592095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2,3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8.1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7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0.9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7.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7.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.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2260552607"/>
                  </a:ext>
                </a:extLst>
              </a:tr>
              <a:tr h="1115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 dirty="0" err="1">
                          <a:effectLst/>
                        </a:rPr>
                        <a:t>Ascosphaeraceae</a:t>
                      </a:r>
                      <a:endParaRPr lang="es-ES" sz="11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 dirty="0" err="1">
                          <a:effectLst/>
                        </a:rPr>
                        <a:t>Ascosphaera</a:t>
                      </a:r>
                      <a:r>
                        <a:rPr lang="es-ES" sz="700" i="1" dirty="0">
                          <a:effectLst/>
                        </a:rPr>
                        <a:t> </a:t>
                      </a:r>
                      <a:r>
                        <a:rPr lang="es-ES" sz="700" i="1" dirty="0" err="1">
                          <a:effectLst/>
                        </a:rPr>
                        <a:t>apis</a:t>
                      </a:r>
                      <a:endParaRPr lang="es-ES" sz="11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ARSEF 740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GCA_001636715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0,3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7.6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8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,369.07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81.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81.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5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3.4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2407684299"/>
                  </a:ext>
                </a:extLst>
              </a:tr>
              <a:tr h="1115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 dirty="0" err="1">
                          <a:effectLst/>
                        </a:rPr>
                        <a:t>Spiromastigoidaceae</a:t>
                      </a:r>
                      <a:endParaRPr lang="es-ES" sz="11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 dirty="0" err="1">
                          <a:effectLst/>
                        </a:rPr>
                        <a:t>Spiromastix</a:t>
                      </a:r>
                      <a:r>
                        <a:rPr lang="es-ES" sz="700" i="1" dirty="0">
                          <a:effectLst/>
                        </a:rPr>
                        <a:t> </a:t>
                      </a:r>
                      <a:r>
                        <a:rPr lang="es-ES" sz="700" i="1" dirty="0" err="1">
                          <a:effectLst/>
                        </a:rPr>
                        <a:t>sp</a:t>
                      </a:r>
                      <a:r>
                        <a:rPr lang="es-ES" sz="700" i="1" dirty="0">
                          <a:effectLst/>
                        </a:rPr>
                        <a:t>.</a:t>
                      </a:r>
                      <a:endParaRPr lang="es-ES" sz="11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SCSIO F19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GCA_014805645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38,1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44.75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2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00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5.9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5.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8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3.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1000696989"/>
                  </a:ext>
                </a:extLst>
              </a:tr>
              <a:tr h="11155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 dirty="0" err="1">
                          <a:effectLst/>
                        </a:rPr>
                        <a:t>Incertae</a:t>
                      </a:r>
                      <a:r>
                        <a:rPr lang="es-ES" sz="700" i="1" dirty="0">
                          <a:effectLst/>
                        </a:rPr>
                        <a:t> </a:t>
                      </a:r>
                      <a:r>
                        <a:rPr lang="es-ES" sz="700" i="1" dirty="0" err="1">
                          <a:effectLst/>
                        </a:rPr>
                        <a:t>sedis</a:t>
                      </a:r>
                      <a:endParaRPr lang="es-ES" sz="11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i="1" dirty="0" err="1">
                          <a:effectLst/>
                        </a:rPr>
                        <a:t>Polytolypa</a:t>
                      </a:r>
                      <a:r>
                        <a:rPr lang="es-ES" sz="700" i="1" dirty="0">
                          <a:effectLst/>
                        </a:rPr>
                        <a:t> </a:t>
                      </a:r>
                      <a:r>
                        <a:rPr lang="es-ES" sz="700" i="1" dirty="0" err="1">
                          <a:effectLst/>
                        </a:rPr>
                        <a:t>hystricis</a:t>
                      </a:r>
                      <a:endParaRPr lang="es-ES" sz="11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UAMH 7299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GCA_002573605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34,69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45.63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64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79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11.26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7.3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97.2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1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>
                          <a:effectLst/>
                        </a:rPr>
                        <a:t>0.9</a:t>
                      </a:r>
                      <a:endParaRPr lang="es-E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700" dirty="0">
                          <a:effectLst/>
                        </a:rPr>
                        <a:t>1.8</a:t>
                      </a:r>
                      <a:endParaRPr lang="es-E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2866226492"/>
                  </a:ext>
                </a:extLst>
              </a:tr>
            </a:tbl>
          </a:graphicData>
        </a:graphic>
      </p:graphicFrame>
      <p:sp>
        <p:nvSpPr>
          <p:cNvPr id="5" name="Rectángulo 4"/>
          <p:cNvSpPr/>
          <p:nvPr/>
        </p:nvSpPr>
        <p:spPr>
          <a:xfrm>
            <a:off x="169805" y="98208"/>
            <a:ext cx="4197927" cy="50862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2800" dirty="0" err="1">
                <a:solidFill>
                  <a:schemeClr val="tx1"/>
                </a:solidFill>
              </a:rPr>
              <a:t>Supplementary</a:t>
            </a:r>
            <a:r>
              <a:rPr lang="es-ES" sz="2800" dirty="0">
                <a:solidFill>
                  <a:schemeClr val="tx1"/>
                </a:solidFill>
              </a:rPr>
              <a:t> </a:t>
            </a:r>
            <a:r>
              <a:rPr lang="es-ES" sz="2800" dirty="0" err="1">
                <a:solidFill>
                  <a:schemeClr val="tx1"/>
                </a:solidFill>
              </a:rPr>
              <a:t>Table</a:t>
            </a:r>
            <a:r>
              <a:rPr lang="es-ES" sz="2800" dirty="0">
                <a:solidFill>
                  <a:schemeClr val="tx1"/>
                </a:solidFill>
              </a:rPr>
              <a:t> 1</a:t>
            </a:r>
          </a:p>
        </p:txBody>
      </p:sp>
      <p:sp>
        <p:nvSpPr>
          <p:cNvPr id="6" name="Rectángulo 5"/>
          <p:cNvSpPr/>
          <p:nvPr/>
        </p:nvSpPr>
        <p:spPr>
          <a:xfrm>
            <a:off x="6505829" y="227265"/>
            <a:ext cx="4599975" cy="25050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just"/>
            <a:r>
              <a:rPr lang="en-US" sz="1000" dirty="0">
                <a:solidFill>
                  <a:schemeClr val="tx1"/>
                </a:solidFill>
              </a:rPr>
              <a:t>Quality statistics of </a:t>
            </a:r>
            <a:r>
              <a:rPr lang="en-US" sz="1000" i="1" dirty="0">
                <a:solidFill>
                  <a:schemeClr val="tx1"/>
                </a:solidFill>
              </a:rPr>
              <a:t>Onygenales </a:t>
            </a:r>
            <a:r>
              <a:rPr lang="en-US" sz="1000" dirty="0">
                <a:solidFill>
                  <a:schemeClr val="tx1"/>
                </a:solidFill>
              </a:rPr>
              <a:t>reference genomes downloaded from NCBI database</a:t>
            </a:r>
          </a:p>
        </p:txBody>
      </p:sp>
    </p:spTree>
    <p:extLst>
      <p:ext uri="{BB962C8B-B14F-4D97-AF65-F5344CB8AC3E}">
        <p14:creationId xmlns:p14="http://schemas.microsoft.com/office/powerpoint/2010/main" val="11156800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Marcador de contenido 3"/>
          <p:cNvGraphicFramePr>
            <a:graphicFrameLocks noGrp="1"/>
          </p:cNvGraphicFramePr>
          <p:nvPr>
            <p:ph idx="1"/>
          </p:nvPr>
        </p:nvGraphicFramePr>
        <p:xfrm>
          <a:off x="623456" y="601665"/>
          <a:ext cx="11011741" cy="594028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48160">
                  <a:extLst>
                    <a:ext uri="{9D8B030D-6E8A-4147-A177-3AD203B41FA5}">
                      <a16:colId xmlns:a16="http://schemas.microsoft.com/office/drawing/2014/main" val="874734498"/>
                    </a:ext>
                  </a:extLst>
                </a:gridCol>
                <a:gridCol w="1041641">
                  <a:extLst>
                    <a:ext uri="{9D8B030D-6E8A-4147-A177-3AD203B41FA5}">
                      <a16:colId xmlns:a16="http://schemas.microsoft.com/office/drawing/2014/main" val="3591733555"/>
                    </a:ext>
                  </a:extLst>
                </a:gridCol>
                <a:gridCol w="1784388">
                  <a:extLst>
                    <a:ext uri="{9D8B030D-6E8A-4147-A177-3AD203B41FA5}">
                      <a16:colId xmlns:a16="http://schemas.microsoft.com/office/drawing/2014/main" val="1950082626"/>
                    </a:ext>
                  </a:extLst>
                </a:gridCol>
                <a:gridCol w="1784388">
                  <a:extLst>
                    <a:ext uri="{9D8B030D-6E8A-4147-A177-3AD203B41FA5}">
                      <a16:colId xmlns:a16="http://schemas.microsoft.com/office/drawing/2014/main" val="1487511901"/>
                    </a:ext>
                  </a:extLst>
                </a:gridCol>
                <a:gridCol w="1784388">
                  <a:extLst>
                    <a:ext uri="{9D8B030D-6E8A-4147-A177-3AD203B41FA5}">
                      <a16:colId xmlns:a16="http://schemas.microsoft.com/office/drawing/2014/main" val="3219963105"/>
                    </a:ext>
                  </a:extLst>
                </a:gridCol>
                <a:gridCol w="1784388">
                  <a:extLst>
                    <a:ext uri="{9D8B030D-6E8A-4147-A177-3AD203B41FA5}">
                      <a16:colId xmlns:a16="http://schemas.microsoft.com/office/drawing/2014/main" val="1331863318"/>
                    </a:ext>
                  </a:extLst>
                </a:gridCol>
                <a:gridCol w="1784388">
                  <a:extLst>
                    <a:ext uri="{9D8B030D-6E8A-4147-A177-3AD203B41FA5}">
                      <a16:colId xmlns:a16="http://schemas.microsoft.com/office/drawing/2014/main" val="2346168723"/>
                    </a:ext>
                  </a:extLst>
                </a:gridCol>
              </a:tblGrid>
              <a:tr h="478990"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b="1" dirty="0" err="1">
                          <a:effectLst/>
                        </a:rPr>
                        <a:t>Species</a:t>
                      </a:r>
                      <a:endParaRPr lang="es-ES" sz="2000" b="1" dirty="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b="1" dirty="0">
                          <a:effectLst/>
                        </a:rPr>
                        <a:t>(</a:t>
                      </a:r>
                      <a:r>
                        <a:rPr lang="es-ES" sz="1050" b="1" dirty="0" err="1">
                          <a:effectLst/>
                        </a:rPr>
                        <a:t>Strain</a:t>
                      </a:r>
                      <a:r>
                        <a:rPr lang="es-ES" sz="1050" b="1" dirty="0">
                          <a:effectLst/>
                        </a:rPr>
                        <a:t>)</a:t>
                      </a:r>
                      <a:endParaRPr lang="es-ES" sz="20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b="1" i="1" dirty="0">
                          <a:effectLst/>
                        </a:rPr>
                        <a:t>Aphanoascus </a:t>
                      </a:r>
                      <a:r>
                        <a:rPr lang="es-ES" sz="1050" b="1" i="1" dirty="0" err="1">
                          <a:effectLst/>
                        </a:rPr>
                        <a:t>verrucosus</a:t>
                      </a:r>
                      <a:endParaRPr lang="es-ES" sz="2000" b="1" i="1" dirty="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b="1" dirty="0">
                          <a:effectLst/>
                        </a:rPr>
                        <a:t>(IHEM 4434)</a:t>
                      </a:r>
                      <a:endParaRPr lang="es-ES" sz="20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b="1" i="1" dirty="0" err="1">
                          <a:effectLst/>
                        </a:rPr>
                        <a:t>Arthroderma</a:t>
                      </a:r>
                      <a:r>
                        <a:rPr lang="es-ES" sz="1050" b="1" i="1" dirty="0">
                          <a:effectLst/>
                        </a:rPr>
                        <a:t> </a:t>
                      </a:r>
                      <a:r>
                        <a:rPr lang="es-ES" sz="1050" b="1" i="1" dirty="0" err="1">
                          <a:effectLst/>
                        </a:rPr>
                        <a:t>uncinatum</a:t>
                      </a:r>
                      <a:r>
                        <a:rPr lang="es-ES" sz="1050" b="1" i="1" dirty="0">
                          <a:effectLst/>
                        </a:rPr>
                        <a:t> </a:t>
                      </a:r>
                      <a:endParaRPr lang="es-ES" sz="2000" b="1" i="1" dirty="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b="1" dirty="0">
                          <a:effectLst/>
                        </a:rPr>
                        <a:t>(CBS 119779)</a:t>
                      </a:r>
                      <a:endParaRPr lang="es-ES" sz="20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b="1" i="1" dirty="0" err="1">
                          <a:effectLst/>
                        </a:rPr>
                        <a:t>Chrysosoporium</a:t>
                      </a:r>
                      <a:r>
                        <a:rPr lang="es-ES" sz="1050" b="1" i="1" dirty="0">
                          <a:effectLst/>
                        </a:rPr>
                        <a:t> </a:t>
                      </a:r>
                      <a:r>
                        <a:rPr lang="es-ES" sz="1050" b="1" i="1" dirty="0" err="1">
                          <a:effectLst/>
                        </a:rPr>
                        <a:t>keratinophilum</a:t>
                      </a:r>
                      <a:endParaRPr lang="es-ES" sz="2000" b="1" i="1" dirty="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b="1" dirty="0">
                          <a:effectLst/>
                        </a:rPr>
                        <a:t>(CBS 104.62)</a:t>
                      </a:r>
                      <a:endParaRPr lang="es-ES" sz="20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b="1" i="1" dirty="0">
                          <a:effectLst/>
                        </a:rPr>
                        <a:t>Nannizzia </a:t>
                      </a:r>
                      <a:r>
                        <a:rPr lang="es-ES" sz="1050" b="1" i="1" dirty="0" err="1">
                          <a:effectLst/>
                        </a:rPr>
                        <a:t>gypsea</a:t>
                      </a:r>
                      <a:r>
                        <a:rPr lang="es-ES" sz="1050" b="1" i="1" dirty="0">
                          <a:effectLst/>
                        </a:rPr>
                        <a:t> </a:t>
                      </a:r>
                      <a:endParaRPr lang="es-ES" sz="2000" b="1" i="1" dirty="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b="1" dirty="0">
                          <a:effectLst/>
                        </a:rPr>
                        <a:t>(CBS 118893)</a:t>
                      </a:r>
                      <a:endParaRPr lang="es-ES" sz="20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b="1" i="1" dirty="0">
                          <a:effectLst/>
                        </a:rPr>
                        <a:t>Trichophyton </a:t>
                      </a:r>
                      <a:r>
                        <a:rPr lang="es-ES" sz="1050" b="1" i="1" dirty="0" err="1">
                          <a:effectLst/>
                        </a:rPr>
                        <a:t>benhamiae</a:t>
                      </a:r>
                      <a:r>
                        <a:rPr lang="es-ES" sz="1050" b="1" i="1" dirty="0">
                          <a:effectLst/>
                        </a:rPr>
                        <a:t> </a:t>
                      </a:r>
                      <a:endParaRPr lang="es-ES" sz="2000" b="1" i="1" dirty="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b="1" dirty="0">
                          <a:effectLst/>
                        </a:rPr>
                        <a:t>(CBS 112371)</a:t>
                      </a:r>
                      <a:endParaRPr lang="es-ES" sz="20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extLst>
                  <a:ext uri="{0D108BD9-81ED-4DB2-BD59-A6C34878D82A}">
                    <a16:rowId xmlns:a16="http://schemas.microsoft.com/office/drawing/2014/main" val="914441324"/>
                  </a:ext>
                </a:extLst>
              </a:tr>
              <a:tr h="240480"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b="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enBank</a:t>
                      </a:r>
                      <a:r>
                        <a:rPr lang="es-ES" sz="1050" b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1050" b="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ssambly</a:t>
                      </a:r>
                      <a:r>
                        <a:rPr lang="es-ES" sz="1050" b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s-ES" sz="1050" b="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ccession</a:t>
                      </a:r>
                      <a:endParaRPr lang="es-ES" sz="1050" b="0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6744" marR="66744" marT="0" marB="0" anchor="ctr"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05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CA_014839905.1</a:t>
                      </a: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CA_011692745.1</a:t>
                      </a: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CA_029850275.1</a:t>
                      </a: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CA_000150975.2</a:t>
                      </a: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CA_000151125.2</a:t>
                      </a:r>
                    </a:p>
                  </a:txBody>
                  <a:tcPr marL="66744" marR="66744" marT="0" marB="0" anchor="ctr"/>
                </a:tc>
                <a:extLst>
                  <a:ext uri="{0D108BD9-81ED-4DB2-BD59-A6C34878D82A}">
                    <a16:rowId xmlns:a16="http://schemas.microsoft.com/office/drawing/2014/main" val="3974596493"/>
                  </a:ext>
                </a:extLst>
              </a:tr>
              <a:tr h="232438"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b="0" dirty="0">
                          <a:effectLst/>
                        </a:rPr>
                        <a:t># Contigs</a:t>
                      </a:r>
                      <a:endParaRPr lang="es-ES" sz="20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dirty="0">
                          <a:effectLst/>
                        </a:rPr>
                        <a:t>211</a:t>
                      </a:r>
                      <a:endParaRPr lang="es-ES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5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25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19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dirty="0">
                          <a:effectLst/>
                        </a:rPr>
                        <a:t>68</a:t>
                      </a:r>
                      <a:endParaRPr lang="es-ES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extLst>
                  <a:ext uri="{0D108BD9-81ED-4DB2-BD59-A6C34878D82A}">
                    <a16:rowId xmlns:a16="http://schemas.microsoft.com/office/drawing/2014/main" val="336905753"/>
                  </a:ext>
                </a:extLst>
              </a:tr>
              <a:tr h="232438"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b="0" dirty="0">
                          <a:effectLst/>
                        </a:rPr>
                        <a:t>Total </a:t>
                      </a:r>
                      <a:r>
                        <a:rPr lang="es-ES" sz="1050" b="0" dirty="0" err="1">
                          <a:effectLst/>
                        </a:rPr>
                        <a:t>length</a:t>
                      </a:r>
                      <a:r>
                        <a:rPr lang="es-ES" sz="1050" b="0" dirty="0">
                          <a:effectLst/>
                        </a:rPr>
                        <a:t> (</a:t>
                      </a:r>
                      <a:r>
                        <a:rPr lang="es-ES" sz="1050" b="0" dirty="0" err="1">
                          <a:effectLst/>
                        </a:rPr>
                        <a:t>bp</a:t>
                      </a:r>
                      <a:r>
                        <a:rPr lang="es-ES" sz="1050" b="0" dirty="0">
                          <a:effectLst/>
                        </a:rPr>
                        <a:t>)</a:t>
                      </a:r>
                      <a:endParaRPr lang="es-ES" sz="20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23,059,040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23,563,256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25,439,844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23,272,942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dirty="0">
                          <a:effectLst/>
                        </a:rPr>
                        <a:t>22,224,160</a:t>
                      </a:r>
                      <a:endParaRPr lang="es-ES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extLst>
                  <a:ext uri="{0D108BD9-81ED-4DB2-BD59-A6C34878D82A}">
                    <a16:rowId xmlns:a16="http://schemas.microsoft.com/office/drawing/2014/main" val="4207516664"/>
                  </a:ext>
                </a:extLst>
              </a:tr>
              <a:tr h="232438"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b="0">
                          <a:effectLst/>
                        </a:rPr>
                        <a:t>Largest contig (bp)</a:t>
                      </a:r>
                      <a:endParaRPr lang="es-ES" sz="20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dirty="0">
                          <a:effectLst/>
                        </a:rPr>
                        <a:t>894,230</a:t>
                      </a:r>
                      <a:endParaRPr lang="es-ES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6,630,942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5,001,415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5,365,613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dirty="0">
                          <a:effectLst/>
                        </a:rPr>
                        <a:t>2,108,575</a:t>
                      </a:r>
                      <a:endParaRPr lang="es-ES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extLst>
                  <a:ext uri="{0D108BD9-81ED-4DB2-BD59-A6C34878D82A}">
                    <a16:rowId xmlns:a16="http://schemas.microsoft.com/office/drawing/2014/main" val="694051714"/>
                  </a:ext>
                </a:extLst>
              </a:tr>
              <a:tr h="232438"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b="0">
                          <a:effectLst/>
                        </a:rPr>
                        <a:t>G+C content (%)</a:t>
                      </a:r>
                      <a:endParaRPr lang="es-ES" sz="20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dirty="0">
                          <a:effectLst/>
                        </a:rPr>
                        <a:t>49.59</a:t>
                      </a:r>
                      <a:endParaRPr lang="es-ES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dirty="0">
                          <a:effectLst/>
                        </a:rPr>
                        <a:t>48.65</a:t>
                      </a:r>
                      <a:endParaRPr lang="es-ES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dirty="0">
                          <a:effectLst/>
                        </a:rPr>
                        <a:t>49.09</a:t>
                      </a:r>
                      <a:endParaRPr lang="es-ES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dirty="0">
                          <a:effectLst/>
                        </a:rPr>
                        <a:t>48.46</a:t>
                      </a:r>
                      <a:endParaRPr lang="es-ES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dirty="0">
                          <a:effectLst/>
                        </a:rPr>
                        <a:t>48.75</a:t>
                      </a:r>
                      <a:endParaRPr lang="es-ES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extLst>
                  <a:ext uri="{0D108BD9-81ED-4DB2-BD59-A6C34878D82A}">
                    <a16:rowId xmlns:a16="http://schemas.microsoft.com/office/drawing/2014/main" val="3742722608"/>
                  </a:ext>
                </a:extLst>
              </a:tr>
              <a:tr h="232438"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b="0">
                          <a:effectLst/>
                        </a:rPr>
                        <a:t>N50 (bp)</a:t>
                      </a:r>
                      <a:endParaRPr lang="es-ES" sz="20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431,853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6,243,631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2,037,736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3,227,799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644,461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extLst>
                  <a:ext uri="{0D108BD9-81ED-4DB2-BD59-A6C34878D82A}">
                    <a16:rowId xmlns:a16="http://schemas.microsoft.com/office/drawing/2014/main" val="3622393848"/>
                  </a:ext>
                </a:extLst>
              </a:tr>
              <a:tr h="232438"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b="0">
                          <a:effectLst/>
                        </a:rPr>
                        <a:t>N90 (bp)</a:t>
                      </a:r>
                      <a:endParaRPr lang="es-ES" sz="20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dirty="0">
                          <a:effectLst/>
                        </a:rPr>
                        <a:t>132,993</a:t>
                      </a:r>
                      <a:endParaRPr lang="es-ES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dirty="0">
                          <a:effectLst/>
                        </a:rPr>
                        <a:t>3,340,665</a:t>
                      </a:r>
                      <a:endParaRPr lang="es-ES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460,884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1,025,350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288,963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extLst>
                  <a:ext uri="{0D108BD9-81ED-4DB2-BD59-A6C34878D82A}">
                    <a16:rowId xmlns:a16="http://schemas.microsoft.com/office/drawing/2014/main" val="4260952155"/>
                  </a:ext>
                </a:extLst>
              </a:tr>
              <a:tr h="232438"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b="0">
                          <a:effectLst/>
                        </a:rPr>
                        <a:t>L50</a:t>
                      </a:r>
                      <a:endParaRPr lang="es-ES" sz="20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17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dirty="0">
                          <a:effectLst/>
                        </a:rPr>
                        <a:t>2</a:t>
                      </a:r>
                      <a:endParaRPr lang="es-ES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4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3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10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extLst>
                  <a:ext uri="{0D108BD9-81ED-4DB2-BD59-A6C34878D82A}">
                    <a16:rowId xmlns:a16="http://schemas.microsoft.com/office/drawing/2014/main" val="2917052921"/>
                  </a:ext>
                </a:extLst>
              </a:tr>
              <a:tr h="232438"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b="0">
                          <a:effectLst/>
                        </a:rPr>
                        <a:t>L90</a:t>
                      </a:r>
                      <a:endParaRPr lang="es-ES" sz="20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52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4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dirty="0">
                          <a:effectLst/>
                        </a:rPr>
                        <a:t>14</a:t>
                      </a:r>
                      <a:endParaRPr lang="es-ES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8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30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extLst>
                  <a:ext uri="{0D108BD9-81ED-4DB2-BD59-A6C34878D82A}">
                    <a16:rowId xmlns:a16="http://schemas.microsoft.com/office/drawing/2014/main" val="1912986209"/>
                  </a:ext>
                </a:extLst>
              </a:tr>
              <a:tr h="232438"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b="0">
                          <a:effectLst/>
                        </a:rPr>
                        <a:t># N's per 100 kbp</a:t>
                      </a:r>
                      <a:endParaRPr lang="es-ES" sz="2000" b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10.51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0.00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dirty="0">
                          <a:effectLst/>
                        </a:rPr>
                        <a:t>10.06</a:t>
                      </a:r>
                      <a:endParaRPr lang="es-ES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676.42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dirty="0">
                          <a:effectLst/>
                        </a:rPr>
                        <a:t>0.02</a:t>
                      </a:r>
                      <a:endParaRPr lang="es-ES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extLst>
                  <a:ext uri="{0D108BD9-81ED-4DB2-BD59-A6C34878D82A}">
                    <a16:rowId xmlns:a16="http://schemas.microsoft.com/office/drawing/2014/main" val="1518234080"/>
                  </a:ext>
                </a:extLst>
              </a:tr>
              <a:tr h="308692">
                <a:tc rowSpan="4">
                  <a:txBody>
                    <a:bodyPr/>
                    <a:lstStyle/>
                    <a:p>
                      <a:pPr marL="71755" marR="71755"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50" b="0" i="1" dirty="0">
                          <a:effectLst/>
                        </a:rPr>
                        <a:t>Onygenales</a:t>
                      </a:r>
                      <a:r>
                        <a:rPr lang="en-US" sz="1050" b="0" dirty="0">
                          <a:effectLst/>
                        </a:rPr>
                        <a:t>_odb10</a:t>
                      </a:r>
                      <a:endParaRPr lang="es-ES" sz="20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vert="vert27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b="0" dirty="0">
                          <a:effectLst/>
                        </a:rPr>
                        <a:t>C* (%)</a:t>
                      </a:r>
                      <a:endParaRPr lang="es-ES" sz="20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96.3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97.6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dirty="0">
                          <a:effectLst/>
                        </a:rPr>
                        <a:t>96.0</a:t>
                      </a:r>
                      <a:endParaRPr lang="es-ES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dirty="0">
                          <a:effectLst/>
                        </a:rPr>
                        <a:t>97.1</a:t>
                      </a:r>
                      <a:endParaRPr lang="es-ES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dirty="0">
                          <a:effectLst/>
                        </a:rPr>
                        <a:t>97.7</a:t>
                      </a:r>
                      <a:endParaRPr lang="es-ES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extLst>
                  <a:ext uri="{0D108BD9-81ED-4DB2-BD59-A6C34878D82A}">
                    <a16:rowId xmlns:a16="http://schemas.microsoft.com/office/drawing/2014/main" val="14541553"/>
                  </a:ext>
                </a:extLst>
              </a:tr>
              <a:tr h="308692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b="0" dirty="0">
                          <a:effectLst/>
                        </a:rPr>
                        <a:t>F* (%)</a:t>
                      </a:r>
                      <a:endParaRPr lang="es-ES" sz="20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0.7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0.5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0.6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dirty="0">
                          <a:effectLst/>
                        </a:rPr>
                        <a:t>1.3</a:t>
                      </a:r>
                      <a:endParaRPr lang="es-ES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0.9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extLst>
                  <a:ext uri="{0D108BD9-81ED-4DB2-BD59-A6C34878D82A}">
                    <a16:rowId xmlns:a16="http://schemas.microsoft.com/office/drawing/2014/main" val="62580092"/>
                  </a:ext>
                </a:extLst>
              </a:tr>
              <a:tr h="308692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b="0" dirty="0">
                          <a:effectLst/>
                        </a:rPr>
                        <a:t>M* (%)</a:t>
                      </a:r>
                      <a:endParaRPr lang="es-ES" sz="20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dirty="0">
                          <a:effectLst/>
                        </a:rPr>
                        <a:t>3.0</a:t>
                      </a:r>
                      <a:endParaRPr lang="es-ES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1.9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3.4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dirty="0">
                          <a:effectLst/>
                        </a:rPr>
                        <a:t>1.6</a:t>
                      </a:r>
                      <a:endParaRPr lang="es-ES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dirty="0">
                          <a:effectLst/>
                        </a:rPr>
                        <a:t>1.4</a:t>
                      </a:r>
                      <a:endParaRPr lang="es-ES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extLst>
                  <a:ext uri="{0D108BD9-81ED-4DB2-BD59-A6C34878D82A}">
                    <a16:rowId xmlns:a16="http://schemas.microsoft.com/office/drawing/2014/main" val="1319696331"/>
                  </a:ext>
                </a:extLst>
              </a:tr>
              <a:tr h="308692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b="0" dirty="0">
                          <a:effectLst/>
                        </a:rPr>
                        <a:t>n*</a:t>
                      </a:r>
                      <a:endParaRPr lang="es-ES" sz="20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dirty="0">
                          <a:effectLst/>
                        </a:rPr>
                        <a:t>4,862</a:t>
                      </a:r>
                      <a:endParaRPr lang="es-ES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dirty="0">
                          <a:effectLst/>
                        </a:rPr>
                        <a:t>4,862</a:t>
                      </a:r>
                      <a:endParaRPr lang="es-ES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4,862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dirty="0">
                          <a:effectLst/>
                        </a:rPr>
                        <a:t>4,862</a:t>
                      </a:r>
                      <a:endParaRPr lang="es-ES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dirty="0">
                          <a:effectLst/>
                        </a:rPr>
                        <a:t>4,862</a:t>
                      </a:r>
                      <a:endParaRPr lang="es-ES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extLst>
                  <a:ext uri="{0D108BD9-81ED-4DB2-BD59-A6C34878D82A}">
                    <a16:rowId xmlns:a16="http://schemas.microsoft.com/office/drawing/2014/main" val="328861869"/>
                  </a:ext>
                </a:extLst>
              </a:tr>
              <a:tr h="232438"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b="0" i="1" dirty="0">
                          <a:effectLst/>
                        </a:rPr>
                        <a:t>Archaea</a:t>
                      </a:r>
                      <a:r>
                        <a:rPr lang="es-ES" sz="1050" b="0" dirty="0">
                          <a:effectLst/>
                        </a:rPr>
                        <a:t>_odb10</a:t>
                      </a:r>
                      <a:endParaRPr lang="es-ES" sz="20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C:18.0%,n:194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dirty="0">
                          <a:effectLst/>
                        </a:rPr>
                        <a:t>C:18.5%,n:194</a:t>
                      </a:r>
                      <a:endParaRPr lang="es-ES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dirty="0">
                          <a:effectLst/>
                        </a:rPr>
                        <a:t>C:19.6%,n:194</a:t>
                      </a:r>
                      <a:endParaRPr lang="es-ES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dirty="0">
                          <a:effectLst/>
                        </a:rPr>
                        <a:t>C:18.0%,n:194</a:t>
                      </a:r>
                      <a:endParaRPr lang="es-ES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dirty="0">
                          <a:effectLst/>
                        </a:rPr>
                        <a:t>C:16.5%,n:194</a:t>
                      </a:r>
                      <a:endParaRPr lang="es-ES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extLst>
                  <a:ext uri="{0D108BD9-81ED-4DB2-BD59-A6C34878D82A}">
                    <a16:rowId xmlns:a16="http://schemas.microsoft.com/office/drawing/2014/main" val="3344935847"/>
                  </a:ext>
                </a:extLst>
              </a:tr>
              <a:tr h="232438"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b="0" i="1" dirty="0">
                          <a:effectLst/>
                        </a:rPr>
                        <a:t>Bacteria</a:t>
                      </a:r>
                      <a:r>
                        <a:rPr lang="es-ES" sz="1050" b="0" dirty="0">
                          <a:effectLst/>
                        </a:rPr>
                        <a:t>_odb10</a:t>
                      </a:r>
                      <a:endParaRPr lang="es-ES" sz="20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dirty="0">
                          <a:effectLst/>
                        </a:rPr>
                        <a:t>C:12.9%,n:124</a:t>
                      </a:r>
                      <a:endParaRPr lang="es-ES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C:12.1%,n:124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C:10.5%,n:124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C:10.5%,n:124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dirty="0">
                          <a:effectLst/>
                        </a:rPr>
                        <a:t>C:10.5%,n:124</a:t>
                      </a:r>
                      <a:endParaRPr lang="es-ES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extLst>
                  <a:ext uri="{0D108BD9-81ED-4DB2-BD59-A6C34878D82A}">
                    <a16:rowId xmlns:a16="http://schemas.microsoft.com/office/drawing/2014/main" val="4048105125"/>
                  </a:ext>
                </a:extLst>
              </a:tr>
              <a:tr h="232438"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b="0" i="1" dirty="0">
                          <a:effectLst/>
                        </a:rPr>
                        <a:t>Eukaryota</a:t>
                      </a:r>
                      <a:r>
                        <a:rPr lang="es-ES" sz="1050" b="0" dirty="0">
                          <a:effectLst/>
                        </a:rPr>
                        <a:t>_odb10</a:t>
                      </a:r>
                      <a:endParaRPr lang="es-ES" sz="20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C:99.2%,n:255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C:98.0%,n:255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C:98.4%,n:255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C:98.4%,n:255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dirty="0">
                          <a:effectLst/>
                        </a:rPr>
                        <a:t>C:97.7%,n:255</a:t>
                      </a:r>
                      <a:endParaRPr lang="es-ES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extLst>
                  <a:ext uri="{0D108BD9-81ED-4DB2-BD59-A6C34878D82A}">
                    <a16:rowId xmlns:a16="http://schemas.microsoft.com/office/drawing/2014/main" val="2771036284"/>
                  </a:ext>
                </a:extLst>
              </a:tr>
              <a:tr h="232438"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b="0" dirty="0" err="1">
                          <a:solidFill>
                            <a:schemeClr val="tx1"/>
                          </a:solidFill>
                          <a:effectLst/>
                        </a:rPr>
                        <a:t>Viruses</a:t>
                      </a:r>
                      <a:endParaRPr lang="es-ES" sz="20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dirty="0">
                          <a:solidFill>
                            <a:schemeClr val="tx1"/>
                          </a:solidFill>
                          <a:effectLst/>
                        </a:rPr>
                        <a:t>0.01</a:t>
                      </a:r>
                      <a:endParaRPr lang="es-ES" sz="20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dirty="0">
                          <a:solidFill>
                            <a:schemeClr val="tx1"/>
                          </a:solidFill>
                          <a:effectLst/>
                        </a:rPr>
                        <a:t>0.02</a:t>
                      </a:r>
                      <a:endParaRPr lang="es-ES" sz="20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0.01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0.01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dirty="0">
                          <a:effectLst/>
                        </a:rPr>
                        <a:t>0.02</a:t>
                      </a:r>
                      <a:endParaRPr lang="es-ES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extLst>
                  <a:ext uri="{0D108BD9-81ED-4DB2-BD59-A6C34878D82A}">
                    <a16:rowId xmlns:a16="http://schemas.microsoft.com/office/drawing/2014/main" val="3317533047"/>
                  </a:ext>
                </a:extLst>
              </a:tr>
              <a:tr h="232438"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b="0" dirty="0" err="1">
                          <a:solidFill>
                            <a:schemeClr val="tx1"/>
                          </a:solidFill>
                          <a:effectLst/>
                        </a:rPr>
                        <a:t>Archaea</a:t>
                      </a:r>
                      <a:endParaRPr lang="es-ES" sz="20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solidFill>
                            <a:schemeClr val="tx1"/>
                          </a:solidFill>
                          <a:effectLst/>
                        </a:rPr>
                        <a:t>0.04</a:t>
                      </a:r>
                      <a:endParaRPr lang="es-ES" sz="20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dirty="0">
                          <a:solidFill>
                            <a:schemeClr val="tx1"/>
                          </a:solidFill>
                          <a:effectLst/>
                        </a:rPr>
                        <a:t>0.06</a:t>
                      </a:r>
                      <a:endParaRPr lang="es-ES" sz="20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0.05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0.07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dirty="0">
                          <a:effectLst/>
                        </a:rPr>
                        <a:t>0.04</a:t>
                      </a:r>
                      <a:endParaRPr lang="es-ES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extLst>
                  <a:ext uri="{0D108BD9-81ED-4DB2-BD59-A6C34878D82A}">
                    <a16:rowId xmlns:a16="http://schemas.microsoft.com/office/drawing/2014/main" val="1217042295"/>
                  </a:ext>
                </a:extLst>
              </a:tr>
              <a:tr h="232438"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b="0" dirty="0">
                          <a:solidFill>
                            <a:schemeClr val="tx1"/>
                          </a:solidFill>
                          <a:effectLst/>
                        </a:rPr>
                        <a:t>Bacteria</a:t>
                      </a:r>
                      <a:endParaRPr lang="es-ES" sz="20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dirty="0">
                          <a:solidFill>
                            <a:schemeClr val="tx1"/>
                          </a:solidFill>
                          <a:effectLst/>
                        </a:rPr>
                        <a:t>1.20</a:t>
                      </a:r>
                      <a:endParaRPr lang="es-ES" sz="20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dirty="0">
                          <a:solidFill>
                            <a:schemeClr val="tx1"/>
                          </a:solidFill>
                          <a:effectLst/>
                        </a:rPr>
                        <a:t>1.10</a:t>
                      </a:r>
                      <a:endParaRPr lang="es-ES" sz="20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1.44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dirty="0">
                          <a:effectLst/>
                        </a:rPr>
                        <a:t>1.11</a:t>
                      </a:r>
                      <a:endParaRPr lang="es-ES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dirty="0">
                          <a:effectLst/>
                        </a:rPr>
                        <a:t>4.98</a:t>
                      </a:r>
                      <a:endParaRPr lang="es-ES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extLst>
                  <a:ext uri="{0D108BD9-81ED-4DB2-BD59-A6C34878D82A}">
                    <a16:rowId xmlns:a16="http://schemas.microsoft.com/office/drawing/2014/main" val="927000736"/>
                  </a:ext>
                </a:extLst>
              </a:tr>
              <a:tr h="232438"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b="0">
                          <a:solidFill>
                            <a:schemeClr val="tx1"/>
                          </a:solidFill>
                          <a:effectLst/>
                        </a:rPr>
                        <a:t>Eukaryota</a:t>
                      </a:r>
                      <a:endParaRPr lang="es-ES" sz="20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dirty="0">
                          <a:solidFill>
                            <a:schemeClr val="tx1"/>
                          </a:solidFill>
                          <a:effectLst/>
                        </a:rPr>
                        <a:t>0.28</a:t>
                      </a:r>
                      <a:endParaRPr lang="es-ES" sz="20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dirty="0">
                          <a:solidFill>
                            <a:schemeClr val="tx1"/>
                          </a:solidFill>
                          <a:effectLst/>
                        </a:rPr>
                        <a:t>1.12</a:t>
                      </a:r>
                      <a:endParaRPr lang="es-ES" sz="20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0.39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0.41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dirty="0">
                          <a:effectLst/>
                        </a:rPr>
                        <a:t>0.58</a:t>
                      </a:r>
                      <a:endParaRPr lang="es-ES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extLst>
                  <a:ext uri="{0D108BD9-81ED-4DB2-BD59-A6C34878D82A}">
                    <a16:rowId xmlns:a16="http://schemas.microsoft.com/office/drawing/2014/main" val="2937015747"/>
                  </a:ext>
                </a:extLst>
              </a:tr>
              <a:tr h="232438"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b="0" dirty="0">
                          <a:solidFill>
                            <a:schemeClr val="tx1"/>
                          </a:solidFill>
                          <a:effectLst/>
                        </a:rPr>
                        <a:t>Total</a:t>
                      </a:r>
                      <a:endParaRPr lang="es-ES" sz="20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dirty="0">
                          <a:solidFill>
                            <a:schemeClr val="tx1"/>
                          </a:solidFill>
                          <a:effectLst/>
                        </a:rPr>
                        <a:t>1.53</a:t>
                      </a:r>
                      <a:endParaRPr lang="es-ES" sz="20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dirty="0">
                          <a:solidFill>
                            <a:schemeClr val="tx1"/>
                          </a:solidFill>
                          <a:effectLst/>
                        </a:rPr>
                        <a:t>2.3</a:t>
                      </a:r>
                      <a:endParaRPr lang="es-ES" sz="20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>
                          <a:effectLst/>
                        </a:rPr>
                        <a:t>1.89</a:t>
                      </a:r>
                      <a:endParaRPr lang="es-ES" sz="2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dirty="0">
                          <a:effectLst/>
                        </a:rPr>
                        <a:t>1.6</a:t>
                      </a:r>
                      <a:endParaRPr lang="es-ES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050" dirty="0">
                          <a:effectLst/>
                        </a:rPr>
                        <a:t>5.61</a:t>
                      </a:r>
                      <a:endParaRPr lang="es-ES" sz="2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6744" marR="66744" marT="0" marB="0" anchor="ctr"/>
                </a:tc>
                <a:extLst>
                  <a:ext uri="{0D108BD9-81ED-4DB2-BD59-A6C34878D82A}">
                    <a16:rowId xmlns:a16="http://schemas.microsoft.com/office/drawing/2014/main" val="2753471771"/>
                  </a:ext>
                </a:extLst>
              </a:tr>
            </a:tbl>
          </a:graphicData>
        </a:graphic>
      </p:graphicFrame>
      <p:sp>
        <p:nvSpPr>
          <p:cNvPr id="5" name="Rectángulo 4"/>
          <p:cNvSpPr/>
          <p:nvPr/>
        </p:nvSpPr>
        <p:spPr>
          <a:xfrm>
            <a:off x="86678" y="35089"/>
            <a:ext cx="4197927" cy="50862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2800" dirty="0" err="1">
                <a:solidFill>
                  <a:schemeClr val="tx1"/>
                </a:solidFill>
              </a:rPr>
              <a:t>Supplementary</a:t>
            </a:r>
            <a:r>
              <a:rPr lang="es-ES" sz="2800" dirty="0">
                <a:solidFill>
                  <a:schemeClr val="tx1"/>
                </a:solidFill>
              </a:rPr>
              <a:t> </a:t>
            </a:r>
            <a:r>
              <a:rPr lang="es-ES" sz="2800" dirty="0" err="1">
                <a:solidFill>
                  <a:schemeClr val="tx1"/>
                </a:solidFill>
              </a:rPr>
              <a:t>Table</a:t>
            </a:r>
            <a:r>
              <a:rPr lang="es-ES" sz="2800" dirty="0">
                <a:solidFill>
                  <a:schemeClr val="tx1"/>
                </a:solidFill>
              </a:rPr>
              <a:t> 2</a:t>
            </a:r>
          </a:p>
        </p:txBody>
      </p:sp>
      <p:sp>
        <p:nvSpPr>
          <p:cNvPr id="6" name="Rectángulo 5"/>
          <p:cNvSpPr/>
          <p:nvPr/>
        </p:nvSpPr>
        <p:spPr>
          <a:xfrm>
            <a:off x="6023690" y="164146"/>
            <a:ext cx="3777015" cy="25050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just"/>
            <a:r>
              <a:rPr lang="en-US" sz="1000" b="1" dirty="0">
                <a:solidFill>
                  <a:schemeClr val="tx1"/>
                </a:solidFill>
              </a:rPr>
              <a:t>Statistics of select genomes that were part of the custom database</a:t>
            </a:r>
          </a:p>
        </p:txBody>
      </p:sp>
      <p:sp>
        <p:nvSpPr>
          <p:cNvPr id="2" name="Rectángulo 1"/>
          <p:cNvSpPr/>
          <p:nvPr/>
        </p:nvSpPr>
        <p:spPr>
          <a:xfrm>
            <a:off x="623456" y="6592281"/>
            <a:ext cx="4732386" cy="215444"/>
          </a:xfrm>
          <a:prstGeom prst="rect">
            <a:avLst/>
          </a:prstGeom>
        </p:spPr>
        <p:txBody>
          <a:bodyPr wrap="none" anchor="ctr">
            <a:spAutoFit/>
          </a:bodyPr>
          <a:lstStyle/>
          <a:p>
            <a:r>
              <a:rPr lang="en-US" sz="8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C*,Complete BUSCOs; F*, </a:t>
            </a:r>
            <a:r>
              <a:rPr lang="en-GB" sz="8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Fragmented BUSCOs; M*, Missing BUSCOs</a:t>
            </a:r>
            <a:r>
              <a:rPr lang="en-US" sz="8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; n,</a:t>
            </a:r>
            <a:r>
              <a:rPr lang="en-US" sz="8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Total BUSCO groups searched</a:t>
            </a:r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422700034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Elipse 11"/>
          <p:cNvSpPr/>
          <p:nvPr/>
        </p:nvSpPr>
        <p:spPr>
          <a:xfrm>
            <a:off x="1080680" y="587014"/>
            <a:ext cx="374073" cy="391422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dirty="0">
                <a:solidFill>
                  <a:schemeClr val="tx1"/>
                </a:solidFill>
              </a:rPr>
              <a:t>A</a:t>
            </a:r>
          </a:p>
        </p:txBody>
      </p:sp>
      <p:sp>
        <p:nvSpPr>
          <p:cNvPr id="13" name="Elipse 12"/>
          <p:cNvSpPr/>
          <p:nvPr/>
        </p:nvSpPr>
        <p:spPr>
          <a:xfrm>
            <a:off x="1080680" y="4149024"/>
            <a:ext cx="374073" cy="391422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dirty="0">
                <a:solidFill>
                  <a:schemeClr val="tx1"/>
                </a:solidFill>
              </a:rPr>
              <a:t>B</a:t>
            </a:r>
          </a:p>
        </p:txBody>
      </p:sp>
      <p:sp>
        <p:nvSpPr>
          <p:cNvPr id="14" name="Rectángulo 13"/>
          <p:cNvSpPr/>
          <p:nvPr/>
        </p:nvSpPr>
        <p:spPr>
          <a:xfrm>
            <a:off x="8886305" y="1511371"/>
            <a:ext cx="2668386" cy="12204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2800" dirty="0" err="1">
                <a:solidFill>
                  <a:schemeClr val="tx1"/>
                </a:solidFill>
              </a:rPr>
              <a:t>Supplementary</a:t>
            </a:r>
            <a:r>
              <a:rPr lang="es-ES" sz="2800" dirty="0">
                <a:solidFill>
                  <a:schemeClr val="tx1"/>
                </a:solidFill>
              </a:rPr>
              <a:t> figure 1</a:t>
            </a:r>
          </a:p>
        </p:txBody>
      </p:sp>
      <p:sp>
        <p:nvSpPr>
          <p:cNvPr id="15" name="Rectángulo 14"/>
          <p:cNvSpPr/>
          <p:nvPr/>
        </p:nvSpPr>
        <p:spPr>
          <a:xfrm>
            <a:off x="8818496" y="3523070"/>
            <a:ext cx="2736195" cy="155670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just"/>
            <a:r>
              <a:rPr lang="en-US" sz="1200" dirty="0">
                <a:solidFill>
                  <a:schemeClr val="tx1"/>
                </a:solidFill>
              </a:rPr>
              <a:t>Maximum likelihood (IQ-TREE) tree of concatenated single copy orthologous using  JTT+I+G4+F model and 1000 </a:t>
            </a:r>
            <a:r>
              <a:rPr lang="es-ES" sz="1200" dirty="0" err="1">
                <a:solidFill>
                  <a:schemeClr val="tx1"/>
                </a:solidFill>
              </a:rPr>
              <a:t>ultrafast</a:t>
            </a:r>
            <a:r>
              <a:rPr lang="es-ES" sz="1200" dirty="0">
                <a:solidFill>
                  <a:schemeClr val="tx1"/>
                </a:solidFill>
              </a:rPr>
              <a:t> </a:t>
            </a:r>
            <a:r>
              <a:rPr lang="en-US" sz="1200" dirty="0">
                <a:solidFill>
                  <a:schemeClr val="tx1"/>
                </a:solidFill>
              </a:rPr>
              <a:t>bootstrap replicates.</a:t>
            </a:r>
          </a:p>
          <a:p>
            <a:pPr algn="just"/>
            <a:r>
              <a:rPr lang="en-US" sz="1200" dirty="0">
                <a:solidFill>
                  <a:schemeClr val="tx1"/>
                </a:solidFill>
              </a:rPr>
              <a:t>A) Analysis performed with the original genomes. B) Analysis performed with the filtered genomes.</a:t>
            </a:r>
          </a:p>
        </p:txBody>
      </p:sp>
      <p:sp>
        <p:nvSpPr>
          <p:cNvPr id="9" name="QuadreDeText 4">
            <a:extLst>
              <a:ext uri="{FF2B5EF4-FFF2-40B4-BE49-F238E27FC236}">
                <a16:creationId xmlns:a16="http://schemas.microsoft.com/office/drawing/2014/main" id="{A1592B98-552B-57E5-E69B-76A1F522EF03}"/>
              </a:ext>
            </a:extLst>
          </p:cNvPr>
          <p:cNvSpPr txBox="1"/>
          <p:nvPr/>
        </p:nvSpPr>
        <p:spPr>
          <a:xfrm>
            <a:off x="0" y="107073"/>
            <a:ext cx="8442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 err="1"/>
              <a:t>Fig</a:t>
            </a:r>
            <a:r>
              <a:rPr lang="es-ES" dirty="0"/>
              <a:t> 6</a:t>
            </a:r>
            <a:endParaRPr lang="ca-ES" dirty="0"/>
          </a:p>
        </p:txBody>
      </p:sp>
      <p:pic>
        <p:nvPicPr>
          <p:cNvPr id="34" name="Imagen 3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2025" y="107073"/>
            <a:ext cx="7391400" cy="3184035"/>
          </a:xfrm>
          <a:prstGeom prst="rect">
            <a:avLst/>
          </a:prstGeom>
        </p:spPr>
      </p:pic>
      <p:pic>
        <p:nvPicPr>
          <p:cNvPr id="35" name="Imagen 3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2025" y="3561170"/>
            <a:ext cx="7391400" cy="31915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836534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ángulo 3"/>
          <p:cNvSpPr/>
          <p:nvPr/>
        </p:nvSpPr>
        <p:spPr>
          <a:xfrm>
            <a:off x="169805" y="98208"/>
            <a:ext cx="4197927" cy="50862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2800" dirty="0" err="1">
                <a:solidFill>
                  <a:schemeClr val="tx1"/>
                </a:solidFill>
              </a:rPr>
              <a:t>Supplementary</a:t>
            </a:r>
            <a:r>
              <a:rPr lang="es-ES" sz="2800" dirty="0">
                <a:solidFill>
                  <a:schemeClr val="tx1"/>
                </a:solidFill>
              </a:rPr>
              <a:t> </a:t>
            </a:r>
            <a:r>
              <a:rPr lang="es-ES" sz="2800" dirty="0" err="1">
                <a:solidFill>
                  <a:schemeClr val="tx1"/>
                </a:solidFill>
              </a:rPr>
              <a:t>Table</a:t>
            </a:r>
            <a:r>
              <a:rPr lang="es-ES" sz="2800" dirty="0">
                <a:solidFill>
                  <a:schemeClr val="tx1"/>
                </a:solidFill>
              </a:rPr>
              <a:t> 3</a:t>
            </a:r>
          </a:p>
        </p:txBody>
      </p:sp>
      <p:graphicFrame>
        <p:nvGraphicFramePr>
          <p:cNvPr id="7" name="Marcador de contenido 6"/>
          <p:cNvGraphicFramePr>
            <a:graphicFrameLocks noGrp="1"/>
          </p:cNvGraphicFramePr>
          <p:nvPr>
            <p:ph idx="1"/>
          </p:nvPr>
        </p:nvGraphicFramePr>
        <p:xfrm>
          <a:off x="284105" y="1079283"/>
          <a:ext cx="11707870" cy="501041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763770">
                  <a:extLst>
                    <a:ext uri="{9D8B030D-6E8A-4147-A177-3AD203B41FA5}">
                      <a16:colId xmlns:a16="http://schemas.microsoft.com/office/drawing/2014/main" val="821973748"/>
                    </a:ext>
                  </a:extLst>
                </a:gridCol>
                <a:gridCol w="1924050">
                  <a:extLst>
                    <a:ext uri="{9D8B030D-6E8A-4147-A177-3AD203B41FA5}">
                      <a16:colId xmlns:a16="http://schemas.microsoft.com/office/drawing/2014/main" val="3314115604"/>
                    </a:ext>
                  </a:extLst>
                </a:gridCol>
                <a:gridCol w="1695450">
                  <a:extLst>
                    <a:ext uri="{9D8B030D-6E8A-4147-A177-3AD203B41FA5}">
                      <a16:colId xmlns:a16="http://schemas.microsoft.com/office/drawing/2014/main" val="786451907"/>
                    </a:ext>
                  </a:extLst>
                </a:gridCol>
                <a:gridCol w="2019300">
                  <a:extLst>
                    <a:ext uri="{9D8B030D-6E8A-4147-A177-3AD203B41FA5}">
                      <a16:colId xmlns:a16="http://schemas.microsoft.com/office/drawing/2014/main" val="4104612480"/>
                    </a:ext>
                  </a:extLst>
                </a:gridCol>
                <a:gridCol w="4305300">
                  <a:extLst>
                    <a:ext uri="{9D8B030D-6E8A-4147-A177-3AD203B41FA5}">
                      <a16:colId xmlns:a16="http://schemas.microsoft.com/office/drawing/2014/main" val="2656955008"/>
                    </a:ext>
                  </a:extLst>
                </a:gridCol>
              </a:tblGrid>
              <a:tr h="816192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600" b="1" dirty="0" err="1">
                          <a:effectLst/>
                          <a:latin typeface="+mn-lt"/>
                        </a:rPr>
                        <a:t>Family</a:t>
                      </a:r>
                      <a:endParaRPr lang="es-ES" sz="16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600" b="1">
                          <a:effectLst/>
                          <a:latin typeface="+mn-lt"/>
                        </a:rPr>
                        <a:t>Strain</a:t>
                      </a:r>
                      <a:endParaRPr lang="es-ES" sz="1600" b="1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600" b="1" dirty="0" err="1">
                          <a:effectLst/>
                          <a:latin typeface="+mn-lt"/>
                        </a:rPr>
                        <a:t>GenBank</a:t>
                      </a:r>
                      <a:r>
                        <a:rPr lang="es-ES" sz="1600" b="1" dirty="0">
                          <a:effectLst/>
                          <a:latin typeface="+mn-lt"/>
                        </a:rPr>
                        <a:t> </a:t>
                      </a:r>
                      <a:r>
                        <a:rPr lang="es-ES" sz="1600" b="1" dirty="0" err="1">
                          <a:effectLst/>
                          <a:latin typeface="+mn-lt"/>
                        </a:rPr>
                        <a:t>assambly</a:t>
                      </a:r>
                      <a:r>
                        <a:rPr lang="es-ES" sz="1600" b="1" dirty="0">
                          <a:effectLst/>
                          <a:latin typeface="+mn-lt"/>
                        </a:rPr>
                        <a:t> </a:t>
                      </a:r>
                      <a:r>
                        <a:rPr lang="es-ES" sz="1600" b="1" dirty="0" err="1">
                          <a:effectLst/>
                          <a:latin typeface="+mn-lt"/>
                        </a:rPr>
                        <a:t>accession</a:t>
                      </a:r>
                      <a:endParaRPr lang="es-ES" sz="16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600" b="1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CBI</a:t>
                      </a:r>
                      <a:r>
                        <a:rPr lang="es-ES" sz="1600" b="1" baseline="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FCS </a:t>
                      </a:r>
                      <a:r>
                        <a:rPr lang="es-ES" sz="1600" b="1" baseline="0" dirty="0" err="1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enome</a:t>
                      </a:r>
                      <a:r>
                        <a:rPr lang="es-ES" sz="1600" b="1" baseline="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s-ES" sz="1600" b="1" baseline="0" dirty="0" err="1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eport</a:t>
                      </a:r>
                      <a:endParaRPr lang="es-ES" sz="1600" b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4186044455"/>
                  </a:ext>
                </a:extLst>
              </a:tr>
              <a:tr h="1048556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600" i="0" dirty="0">
                          <a:effectLst/>
                          <a:latin typeface="+mn-lt"/>
                        </a:rPr>
                        <a:t>Onygenaceae</a:t>
                      </a:r>
                      <a:endParaRPr lang="es-ES" sz="1600" i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600" i="1" dirty="0">
                          <a:effectLst/>
                          <a:latin typeface="+mn-lt"/>
                        </a:rPr>
                        <a:t>Amauroascus </a:t>
                      </a:r>
                      <a:r>
                        <a:rPr lang="es-ES" sz="1600" i="1" dirty="0" err="1">
                          <a:effectLst/>
                          <a:latin typeface="+mn-lt"/>
                        </a:rPr>
                        <a:t>niger</a:t>
                      </a:r>
                      <a:endParaRPr lang="es-ES" sz="1600" i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600" dirty="0">
                          <a:effectLst/>
                          <a:latin typeface="+mn-lt"/>
                        </a:rPr>
                        <a:t>UAMH 3544</a:t>
                      </a:r>
                      <a:endParaRPr lang="es-ES" sz="16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600" dirty="0">
                          <a:effectLst/>
                          <a:latin typeface="+mn-lt"/>
                        </a:rPr>
                        <a:t>GCA_001430945.1</a:t>
                      </a:r>
                      <a:endParaRPr lang="es-ES" sz="16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600" i="1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  <a:hlinkClick r:id="rId2"/>
                        </a:rPr>
                        <a:t>https://ftp.ncbi.nlm.nih.gov/genomes/all/GCA/001/430/945/GCA_001430945.1_ASM143094v1/GCA_001430945.1_ASM143094v1_fcs_report.txt</a:t>
                      </a:r>
                      <a:endParaRPr lang="es-ES" sz="1600" i="1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728954766"/>
                  </a:ext>
                </a:extLst>
              </a:tr>
              <a:tr h="1048556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600" i="0" dirty="0">
                          <a:effectLst/>
                          <a:latin typeface="+mn-lt"/>
                        </a:rPr>
                        <a:t>Onygenaceae</a:t>
                      </a:r>
                      <a:endParaRPr lang="es-ES" sz="1600" i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600" i="1" dirty="0">
                          <a:effectLst/>
                          <a:latin typeface="+mn-lt"/>
                        </a:rPr>
                        <a:t>Amauroascus </a:t>
                      </a:r>
                      <a:r>
                        <a:rPr lang="es-ES" sz="1600" i="1" dirty="0" err="1">
                          <a:effectLst/>
                          <a:latin typeface="+mn-lt"/>
                        </a:rPr>
                        <a:t>verrucosus</a:t>
                      </a:r>
                      <a:endParaRPr lang="es-ES" sz="1600" i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600" dirty="0">
                          <a:effectLst/>
                          <a:latin typeface="+mn-lt"/>
                        </a:rPr>
                        <a:t>UAMH 3576</a:t>
                      </a:r>
                      <a:endParaRPr lang="es-ES" sz="16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600" dirty="0">
                          <a:effectLst/>
                          <a:latin typeface="+mn-lt"/>
                        </a:rPr>
                        <a:t>GCA_001430935.1</a:t>
                      </a:r>
                      <a:endParaRPr lang="es-ES" sz="16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600" i="1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  <a:hlinkClick r:id="rId3"/>
                        </a:rPr>
                        <a:t>https://ftp.ncbi.nlm.nih.gov/genomes/all/GCA/001/430/935/GCA_001430935.1_ASM143093v1/GCA_001430935.1_ASM143093v1_fcs_report.txt</a:t>
                      </a:r>
                      <a:endParaRPr lang="es-ES" sz="1600" i="1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730292935"/>
                  </a:ext>
                </a:extLst>
              </a:tr>
              <a:tr h="1048556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600" i="0" dirty="0">
                          <a:effectLst/>
                          <a:latin typeface="+mn-lt"/>
                        </a:rPr>
                        <a:t>Onygenaceae</a:t>
                      </a:r>
                      <a:endParaRPr lang="es-ES" sz="1600" i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600" i="1" dirty="0">
                          <a:effectLst/>
                          <a:latin typeface="+mn-lt"/>
                        </a:rPr>
                        <a:t>Aphanoascus </a:t>
                      </a:r>
                      <a:r>
                        <a:rPr lang="es-ES" sz="1600" i="1" dirty="0" err="1">
                          <a:effectLst/>
                          <a:latin typeface="+mn-lt"/>
                        </a:rPr>
                        <a:t>verrucosus</a:t>
                      </a:r>
                      <a:endParaRPr lang="es-ES" sz="1600" i="1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600" dirty="0">
                          <a:effectLst/>
                          <a:latin typeface="+mn-lt"/>
                        </a:rPr>
                        <a:t>IHEM 4434</a:t>
                      </a:r>
                      <a:endParaRPr lang="es-ES" sz="16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600" dirty="0">
                          <a:effectLst/>
                          <a:latin typeface="+mn-lt"/>
                        </a:rPr>
                        <a:t>GCA_014839905.1</a:t>
                      </a:r>
                      <a:endParaRPr lang="es-ES" sz="16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600" dirty="0">
                          <a:latin typeface="+mn-lt"/>
                          <a:hlinkClick r:id="rId4"/>
                        </a:rPr>
                        <a:t>https://ftp.ncbi.nlm.nih.gov/genomes/all/GCA/001/430/925/GCA_001430925.1_ASM143092v1/GCA_001430925.1_ASM143092v1_fcs_report.txt</a:t>
                      </a:r>
                      <a:endParaRPr lang="es-ES" sz="1600" i="1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2891444905"/>
                  </a:ext>
                </a:extLst>
              </a:tr>
              <a:tr h="1048556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600" i="0" dirty="0">
                          <a:effectLst/>
                          <a:latin typeface="+mn-lt"/>
                        </a:rPr>
                        <a:t>Onygenaceae</a:t>
                      </a:r>
                      <a:endParaRPr lang="es-ES" sz="1600" i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600" i="1">
                          <a:effectLst/>
                          <a:latin typeface="+mn-lt"/>
                        </a:rPr>
                        <a:t>Brunneospora queenslandica</a:t>
                      </a:r>
                      <a:endParaRPr lang="es-ES" sz="1600" i="1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600" dirty="0">
                          <a:effectLst/>
                          <a:latin typeface="+mn-lt"/>
                        </a:rPr>
                        <a:t>CBS 280.77</a:t>
                      </a:r>
                      <a:endParaRPr lang="es-ES" sz="16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600" dirty="0">
                          <a:effectLst/>
                          <a:latin typeface="+mn-lt"/>
                        </a:rPr>
                        <a:t>GCA_001430955.1</a:t>
                      </a:r>
                      <a:endParaRPr lang="es-ES" sz="16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992" marR="60992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s-ES" sz="1600" i="1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  <a:hlinkClick r:id="rId5"/>
                        </a:rPr>
                        <a:t>https://ftp.ncbi.nlm.nih.gov/genomes/all/GCA/001/430/955/GCA_001430955.1_ASM143095v1/GCA_001430955.1_ASM143095v1_fcs_report.txt</a:t>
                      </a:r>
                      <a:endParaRPr lang="es-ES" sz="1600" i="1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0992" marR="60992" marT="0" marB="0" anchor="ctr"/>
                </a:tc>
                <a:extLst>
                  <a:ext uri="{0D108BD9-81ED-4DB2-BD59-A6C34878D82A}">
                    <a16:rowId xmlns:a16="http://schemas.microsoft.com/office/drawing/2014/main" val="2160367409"/>
                  </a:ext>
                </a:extLst>
              </a:tr>
            </a:tbl>
          </a:graphicData>
        </a:graphic>
      </p:graphicFrame>
      <p:sp>
        <p:nvSpPr>
          <p:cNvPr id="8" name="Rectángulo 7"/>
          <p:cNvSpPr/>
          <p:nvPr/>
        </p:nvSpPr>
        <p:spPr>
          <a:xfrm>
            <a:off x="6138040" y="467296"/>
            <a:ext cx="2839928" cy="25050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just"/>
            <a:r>
              <a:rPr lang="en-US" sz="1000" b="1" dirty="0">
                <a:solidFill>
                  <a:schemeClr val="tx1"/>
                </a:solidFill>
              </a:rPr>
              <a:t>NCBI FCS  genome report from analyzed genomes</a:t>
            </a:r>
          </a:p>
        </p:txBody>
      </p:sp>
    </p:spTree>
    <p:extLst>
      <p:ext uri="{BB962C8B-B14F-4D97-AF65-F5344CB8AC3E}">
        <p14:creationId xmlns:p14="http://schemas.microsoft.com/office/powerpoint/2010/main" val="257855214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07</Words>
  <Application>Microsoft Macintosh PowerPoint</Application>
  <PresentationFormat>Panorámica</PresentationFormat>
  <Paragraphs>868</Paragraphs>
  <Slides>5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5</vt:i4>
      </vt:variant>
    </vt:vector>
  </HeadingPairs>
  <TitlesOfParts>
    <vt:vector size="11" baseType="lpstr">
      <vt:lpstr>Aptos</vt:lpstr>
      <vt:lpstr>Aptos Display</vt:lpstr>
      <vt:lpstr>Arial</vt:lpstr>
      <vt:lpstr>Calibri</vt:lpstr>
      <vt:lpstr>Palatino Linotype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na Fernández Bravo</dc:creator>
  <cp:lastModifiedBy>Ana Fernández Bravo</cp:lastModifiedBy>
  <cp:revision>1</cp:revision>
  <dcterms:created xsi:type="dcterms:W3CDTF">2025-07-24T10:50:13Z</dcterms:created>
  <dcterms:modified xsi:type="dcterms:W3CDTF">2025-07-24T10:51:04Z</dcterms:modified>
</cp:coreProperties>
</file>